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410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00CC00"/>
    <a:srgbClr val="D9D9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7853C-536D-4A76-A0AE-DD22124D55A5}" styleName="テーマ スタイル 1 - アクセント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69" autoAdjust="0"/>
    <p:restoredTop sz="94954" autoAdjust="0"/>
  </p:normalViewPr>
  <p:slideViewPr>
    <p:cSldViewPr snapToGrid="0">
      <p:cViewPr varScale="1">
        <p:scale>
          <a:sx n="74" d="100"/>
          <a:sy n="74" d="100"/>
        </p:scale>
        <p:origin x="1642" y="5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5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44" y="3"/>
            <a:ext cx="2949786" cy="498693"/>
          </a:xfrm>
          <a:prstGeom prst="rect">
            <a:avLst/>
          </a:prstGeom>
        </p:spPr>
        <p:txBody>
          <a:bodyPr vert="horz" lIns="95624" tIns="47814" rIns="95624" bIns="47814" rtlCol="0"/>
          <a:lstStyle>
            <a:lvl1pPr algn="r">
              <a:defRPr sz="1300"/>
            </a:lvl1pPr>
          </a:lstStyle>
          <a:p>
            <a:fld id="{77AA9483-565E-46D9-A842-79CD4DF778D0}" type="datetimeFigureOut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5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l">
              <a:defRPr sz="13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44" y="9440648"/>
            <a:ext cx="2949786" cy="498692"/>
          </a:xfrm>
          <a:prstGeom prst="rect">
            <a:avLst/>
          </a:prstGeom>
        </p:spPr>
        <p:txBody>
          <a:bodyPr vert="horz" lIns="95624" tIns="47814" rIns="95624" bIns="47814" rtlCol="0" anchor="b"/>
          <a:lstStyle>
            <a:lvl1pPr algn="r">
              <a:defRPr sz="1300"/>
            </a:lvl1pPr>
          </a:lstStyle>
          <a:p>
            <a:fld id="{F33174FD-3531-4AD8-AF7A-64487AF244F6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54685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6" y="6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146" y="6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/>
          <a:lstStyle>
            <a:lvl1pPr algn="r">
              <a:defRPr sz="1200"/>
            </a:lvl1pPr>
          </a:lstStyle>
          <a:p>
            <a:fld id="{967D371C-0BC3-47E7-8070-1D8FD1977CE7}" type="datetimeFigureOut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69988" y="1243013"/>
            <a:ext cx="447040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8255" tIns="44127" rIns="88255" bIns="44127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480" y="4783900"/>
            <a:ext cx="5445760" cy="3912834"/>
          </a:xfrm>
          <a:prstGeom prst="rect">
            <a:avLst/>
          </a:prstGeom>
        </p:spPr>
        <p:txBody>
          <a:bodyPr vert="horz" lIns="88255" tIns="44127" rIns="88255" bIns="44127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6" y="9441374"/>
            <a:ext cx="2949533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146" y="9441374"/>
            <a:ext cx="2949532" cy="497969"/>
          </a:xfrm>
          <a:prstGeom prst="rect">
            <a:avLst/>
          </a:prstGeom>
        </p:spPr>
        <p:txBody>
          <a:bodyPr vert="horz" lIns="88255" tIns="44127" rIns="88255" bIns="44127" rtlCol="0" anchor="b"/>
          <a:lstStyle>
            <a:lvl1pPr algn="r">
              <a:defRPr sz="1200"/>
            </a:lvl1pPr>
          </a:lstStyle>
          <a:p>
            <a:fld id="{8087B928-A29C-4023-B70B-14035D670E3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995196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E34DCA-D378-4CBA-B2EB-93C479760CB0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163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7BCBA4-CF1C-4256-B860-9AA9E7FB8F04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54079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5E0B85-B1A1-420B-8C58-5608326397E3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27927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A5F2AD-7792-4694-8A8D-47038094A2F6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869313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A3A5AA-51B3-4289-92E7-56B34844DC67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32433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6D8A87-828D-49E8-A499-33D151351DDD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57634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88CF2-512A-43F6-A490-B679F1114C95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28328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67687B-7EE4-45EB-8EF6-70E0D13ADE99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96728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1E90B6-349F-44D5-A782-8BAC83707F4E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42946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95BB9-420E-4F1B-9995-3D589F84EF36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61817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B4C5CE-5E4E-41FD-8680-1EA160B04991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93225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73DC1-41A9-4AF1-8DBE-785BCAA55A2A}" type="datetime1">
              <a:rPr kumimoji="1" lang="ja-JP" altLang="en-US" smtClean="0"/>
              <a:t>2019/9/26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791E06-C951-4ABD-B4AE-592C1CA408F4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893103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7" name="グループ化 296"/>
          <p:cNvGrpSpPr/>
          <p:nvPr/>
        </p:nvGrpSpPr>
        <p:grpSpPr>
          <a:xfrm>
            <a:off x="1136232" y="878684"/>
            <a:ext cx="6948716" cy="3779480"/>
            <a:chOff x="771929" y="2066803"/>
            <a:chExt cx="6948716" cy="3779480"/>
          </a:xfrm>
        </p:grpSpPr>
        <p:sp>
          <p:nvSpPr>
            <p:cNvPr id="267" name="テキスト ボックス 266"/>
            <p:cNvSpPr txBox="1"/>
            <p:nvPr/>
          </p:nvSpPr>
          <p:spPr>
            <a:xfrm rot="-2700000">
              <a:off x="1126457" y="5057873"/>
              <a:ext cx="115288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l UC patients</a:t>
              </a:r>
            </a:p>
            <a:p>
              <a:pPr algn="r"/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(n = 252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テキスト ボックス 267"/>
            <p:cNvSpPr txBox="1"/>
            <p:nvPr/>
          </p:nvSpPr>
          <p:spPr>
            <a:xfrm rot="-2700000">
              <a:off x="2179119" y="5055629"/>
              <a:ext cx="11592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lderly patients</a:t>
              </a:r>
            </a:p>
            <a:p>
              <a:pPr algn="r"/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n = 91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テキスト ボックス 268"/>
            <p:cNvSpPr txBox="1"/>
            <p:nvPr/>
          </p:nvSpPr>
          <p:spPr>
            <a:xfrm rot="18900000">
              <a:off x="2922269" y="5199952"/>
              <a:ext cx="1577676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ho received </a:t>
              </a:r>
            </a:p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MA retreatment</a:t>
              </a:r>
            </a:p>
            <a:p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         </a:t>
              </a:r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78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0" name="テキスト ボックス 269"/>
            <p:cNvSpPr txBox="1"/>
            <p:nvPr/>
          </p:nvSpPr>
          <p:spPr>
            <a:xfrm rot="18900000">
              <a:off x="4009363" y="5220122"/>
              <a:ext cx="15408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with anaemia</a:t>
              </a:r>
            </a:p>
            <a:p>
              <a:pPr algn="r"/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59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1" name="テキスト ボックス 270"/>
            <p:cNvSpPr txBox="1"/>
            <p:nvPr/>
          </p:nvSpPr>
          <p:spPr>
            <a:xfrm rot="18900000">
              <a:off x="4932337" y="5287201"/>
              <a:ext cx="175400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tients on corticosteroid</a:t>
              </a:r>
            </a:p>
            <a:p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lus </a:t>
              </a:r>
              <a:r>
                <a:rPr lang="en-US" altLang="ja-JP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iopurine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39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2" name="テキスト ボックス 271"/>
            <p:cNvSpPr txBox="1"/>
            <p:nvPr/>
          </p:nvSpPr>
          <p:spPr>
            <a:xfrm rot="-2700000">
              <a:off x="6099049" y="5209831"/>
              <a:ext cx="149912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ediatric/adolescent</a:t>
              </a:r>
            </a:p>
            <a:p>
              <a:pPr algn="r"/>
              <a:r>
                <a:rPr lang="en-US" altLang="ja-JP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</a:t>
              </a:r>
              <a:r>
                <a:rPr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ients </a:t>
              </a:r>
              <a:r>
                <a:rPr kumimoji="1" lang="en-US" altLang="ja-JP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n = 29)</a:t>
              </a:r>
              <a:endPara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96" name="グループ化 295"/>
            <p:cNvGrpSpPr/>
            <p:nvPr/>
          </p:nvGrpSpPr>
          <p:grpSpPr>
            <a:xfrm>
              <a:off x="1102318" y="2066803"/>
              <a:ext cx="6618327" cy="2799009"/>
              <a:chOff x="1102318" y="2066803"/>
              <a:chExt cx="6618327" cy="2799009"/>
            </a:xfrm>
          </p:grpSpPr>
          <p:sp>
            <p:nvSpPr>
              <p:cNvPr id="25" name="Freeform 6"/>
              <p:cNvSpPr>
                <a:spLocks noEditPoints="1"/>
              </p:cNvSpPr>
              <p:nvPr/>
            </p:nvSpPr>
            <p:spPr bwMode="auto">
              <a:xfrm>
                <a:off x="1726289" y="3313863"/>
                <a:ext cx="0" cy="536575"/>
              </a:xfrm>
              <a:custGeom>
                <a:avLst/>
                <a:gdLst>
                  <a:gd name="T0" fmla="*/ 98 h 98"/>
                  <a:gd name="T1" fmla="*/ 94 h 98"/>
                  <a:gd name="T2" fmla="*/ 90 h 98"/>
                  <a:gd name="T3" fmla="*/ 86 h 98"/>
                  <a:gd name="T4" fmla="*/ 82 h 98"/>
                  <a:gd name="T5" fmla="*/ 78 h 98"/>
                  <a:gd name="T6" fmla="*/ 74 h 98"/>
                  <a:gd name="T7" fmla="*/ 70 h 98"/>
                  <a:gd name="T8" fmla="*/ 66 h 98"/>
                  <a:gd name="T9" fmla="*/ 62 h 98"/>
                  <a:gd name="T10" fmla="*/ 58 h 98"/>
                  <a:gd name="T11" fmla="*/ 54 h 98"/>
                  <a:gd name="T12" fmla="*/ 50 h 98"/>
                  <a:gd name="T13" fmla="*/ 46 h 98"/>
                  <a:gd name="T14" fmla="*/ 42 h 98"/>
                  <a:gd name="T15" fmla="*/ 38 h 98"/>
                  <a:gd name="T16" fmla="*/ 34 h 98"/>
                  <a:gd name="T17" fmla="*/ 30 h 98"/>
                  <a:gd name="T18" fmla="*/ 26 h 98"/>
                  <a:gd name="T19" fmla="*/ 22 h 98"/>
                  <a:gd name="T20" fmla="*/ 18 h 98"/>
                  <a:gd name="T21" fmla="*/ 14 h 98"/>
                  <a:gd name="T22" fmla="*/ 10 h 98"/>
                  <a:gd name="T23" fmla="*/ 6 h 98"/>
                  <a:gd name="T24" fmla="*/ 2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94"/>
                    </a:moveTo>
                    <a:lnTo>
                      <a:pt x="0" y="90"/>
                    </a:lnTo>
                    <a:moveTo>
                      <a:pt x="0" y="86"/>
                    </a:moveTo>
                    <a:lnTo>
                      <a:pt x="0" y="82"/>
                    </a:lnTo>
                    <a:moveTo>
                      <a:pt x="0" y="78"/>
                    </a:moveTo>
                    <a:lnTo>
                      <a:pt x="0" y="74"/>
                    </a:lnTo>
                    <a:moveTo>
                      <a:pt x="0" y="70"/>
                    </a:moveTo>
                    <a:lnTo>
                      <a:pt x="0" y="66"/>
                    </a:lnTo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6" name="Freeform 7"/>
              <p:cNvSpPr>
                <a:spLocks noEditPoints="1"/>
              </p:cNvSpPr>
              <p:nvPr/>
            </p:nvSpPr>
            <p:spPr bwMode="auto">
              <a:xfrm>
                <a:off x="1726289" y="2215313"/>
                <a:ext cx="0" cy="538163"/>
              </a:xfrm>
              <a:custGeom>
                <a:avLst/>
                <a:gdLst>
                  <a:gd name="T0" fmla="*/ 0 h 98"/>
                  <a:gd name="T1" fmla="*/ 4 h 98"/>
                  <a:gd name="T2" fmla="*/ 8 h 98"/>
                  <a:gd name="T3" fmla="*/ 12 h 98"/>
                  <a:gd name="T4" fmla="*/ 16 h 98"/>
                  <a:gd name="T5" fmla="*/ 20 h 98"/>
                  <a:gd name="T6" fmla="*/ 24 h 98"/>
                  <a:gd name="T7" fmla="*/ 28 h 98"/>
                  <a:gd name="T8" fmla="*/ 32 h 98"/>
                  <a:gd name="T9" fmla="*/ 36 h 98"/>
                  <a:gd name="T10" fmla="*/ 40 h 98"/>
                  <a:gd name="T11" fmla="*/ 44 h 98"/>
                  <a:gd name="T12" fmla="*/ 48 h 98"/>
                  <a:gd name="T13" fmla="*/ 52 h 98"/>
                  <a:gd name="T14" fmla="*/ 56 h 98"/>
                  <a:gd name="T15" fmla="*/ 60 h 98"/>
                  <a:gd name="T16" fmla="*/ 64 h 98"/>
                  <a:gd name="T17" fmla="*/ 68 h 98"/>
                  <a:gd name="T18" fmla="*/ 72 h 98"/>
                  <a:gd name="T19" fmla="*/ 76 h 98"/>
                  <a:gd name="T20" fmla="*/ 80 h 98"/>
                  <a:gd name="T21" fmla="*/ 84 h 98"/>
                  <a:gd name="T22" fmla="*/ 88 h 98"/>
                  <a:gd name="T23" fmla="*/ 92 h 98"/>
                  <a:gd name="T24" fmla="*/ 96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7" name="Line 8"/>
              <p:cNvSpPr>
                <a:spLocks noChangeShapeType="1"/>
              </p:cNvSpPr>
              <p:nvPr/>
            </p:nvSpPr>
            <p:spPr bwMode="auto">
              <a:xfrm>
                <a:off x="1620072" y="387266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8" name="Line 9"/>
              <p:cNvSpPr>
                <a:spLocks noChangeShapeType="1"/>
              </p:cNvSpPr>
              <p:nvPr/>
            </p:nvSpPr>
            <p:spPr bwMode="auto">
              <a:xfrm>
                <a:off x="1620072" y="2193088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9" name="Rectangle 10"/>
              <p:cNvSpPr>
                <a:spLocks noChangeArrowheads="1"/>
              </p:cNvSpPr>
              <p:nvPr/>
            </p:nvSpPr>
            <p:spPr bwMode="auto">
              <a:xfrm>
                <a:off x="1549065" y="2753475"/>
                <a:ext cx="360000" cy="5603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31" name="Freeform 12"/>
              <p:cNvSpPr>
                <a:spLocks noEditPoints="1"/>
              </p:cNvSpPr>
              <p:nvPr/>
            </p:nvSpPr>
            <p:spPr bwMode="auto">
              <a:xfrm>
                <a:off x="2139550" y="2775700"/>
                <a:ext cx="0" cy="1096963"/>
              </a:xfrm>
              <a:custGeom>
                <a:avLst/>
                <a:gdLst>
                  <a:gd name="T0" fmla="*/ 0 h 200"/>
                  <a:gd name="T1" fmla="*/ 4 h 200"/>
                  <a:gd name="T2" fmla="*/ 8 h 200"/>
                  <a:gd name="T3" fmla="*/ 12 h 200"/>
                  <a:gd name="T4" fmla="*/ 16 h 200"/>
                  <a:gd name="T5" fmla="*/ 20 h 200"/>
                  <a:gd name="T6" fmla="*/ 24 h 200"/>
                  <a:gd name="T7" fmla="*/ 28 h 200"/>
                  <a:gd name="T8" fmla="*/ 32 h 200"/>
                  <a:gd name="T9" fmla="*/ 36 h 200"/>
                  <a:gd name="T10" fmla="*/ 40 h 200"/>
                  <a:gd name="T11" fmla="*/ 44 h 200"/>
                  <a:gd name="T12" fmla="*/ 48 h 200"/>
                  <a:gd name="T13" fmla="*/ 52 h 200"/>
                  <a:gd name="T14" fmla="*/ 56 h 200"/>
                  <a:gd name="T15" fmla="*/ 60 h 200"/>
                  <a:gd name="T16" fmla="*/ 64 h 200"/>
                  <a:gd name="T17" fmla="*/ 68 h 200"/>
                  <a:gd name="T18" fmla="*/ 72 h 200"/>
                  <a:gd name="T19" fmla="*/ 76 h 200"/>
                  <a:gd name="T20" fmla="*/ 80 h 200"/>
                  <a:gd name="T21" fmla="*/ 84 h 200"/>
                  <a:gd name="T22" fmla="*/ 88 h 200"/>
                  <a:gd name="T23" fmla="*/ 92 h 200"/>
                  <a:gd name="T24" fmla="*/ 96 h 200"/>
                  <a:gd name="T25" fmla="*/ 100 h 200"/>
                  <a:gd name="T26" fmla="*/ 104 h 200"/>
                  <a:gd name="T27" fmla="*/ 108 h 200"/>
                  <a:gd name="T28" fmla="*/ 112 h 200"/>
                  <a:gd name="T29" fmla="*/ 116 h 200"/>
                  <a:gd name="T30" fmla="*/ 120 h 200"/>
                  <a:gd name="T31" fmla="*/ 124 h 200"/>
                  <a:gd name="T32" fmla="*/ 128 h 200"/>
                  <a:gd name="T33" fmla="*/ 132 h 200"/>
                  <a:gd name="T34" fmla="*/ 136 h 200"/>
                  <a:gd name="T35" fmla="*/ 140 h 200"/>
                  <a:gd name="T36" fmla="*/ 144 h 200"/>
                  <a:gd name="T37" fmla="*/ 148 h 200"/>
                  <a:gd name="T38" fmla="*/ 152 h 200"/>
                  <a:gd name="T39" fmla="*/ 156 h 200"/>
                  <a:gd name="T40" fmla="*/ 160 h 200"/>
                  <a:gd name="T41" fmla="*/ 164 h 200"/>
                  <a:gd name="T42" fmla="*/ 168 h 200"/>
                  <a:gd name="T43" fmla="*/ 172 h 200"/>
                  <a:gd name="T44" fmla="*/ 176 h 200"/>
                  <a:gd name="T45" fmla="*/ 180 h 200"/>
                  <a:gd name="T46" fmla="*/ 184 h 200"/>
                  <a:gd name="T47" fmla="*/ 188 h 200"/>
                  <a:gd name="T48" fmla="*/ 192 h 200"/>
                  <a:gd name="T49" fmla="*/ 196 h 20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  <a:cxn ang="0">
                    <a:pos x="0" y="T47"/>
                  </a:cxn>
                  <a:cxn ang="0">
                    <a:pos x="0" y="T48"/>
                  </a:cxn>
                  <a:cxn ang="0">
                    <a:pos x="0" y="T49"/>
                  </a:cxn>
                </a:cxnLst>
                <a:rect l="0" t="0" r="r" b="b"/>
                <a:pathLst>
                  <a:path h="20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  <a:lnTo>
                      <a:pt x="0" y="152"/>
                    </a:lnTo>
                    <a:moveTo>
                      <a:pt x="0" y="156"/>
                    </a:moveTo>
                    <a:lnTo>
                      <a:pt x="0" y="160"/>
                    </a:lnTo>
                    <a:moveTo>
                      <a:pt x="0" y="164"/>
                    </a:moveTo>
                    <a:lnTo>
                      <a:pt x="0" y="168"/>
                    </a:lnTo>
                    <a:moveTo>
                      <a:pt x="0" y="172"/>
                    </a:moveTo>
                    <a:lnTo>
                      <a:pt x="0" y="176"/>
                    </a:lnTo>
                    <a:moveTo>
                      <a:pt x="0" y="180"/>
                    </a:moveTo>
                    <a:lnTo>
                      <a:pt x="0" y="184"/>
                    </a:lnTo>
                    <a:moveTo>
                      <a:pt x="0" y="188"/>
                    </a:moveTo>
                    <a:lnTo>
                      <a:pt x="0" y="192"/>
                    </a:lnTo>
                    <a:moveTo>
                      <a:pt x="0" y="196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32" name="Line 13"/>
              <p:cNvSpPr>
                <a:spLocks noChangeShapeType="1"/>
              </p:cNvSpPr>
              <p:nvPr/>
            </p:nvSpPr>
            <p:spPr bwMode="auto">
              <a:xfrm>
                <a:off x="2047186" y="4712450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33" name="Line 14"/>
              <p:cNvSpPr>
                <a:spLocks noChangeShapeType="1"/>
              </p:cNvSpPr>
              <p:nvPr/>
            </p:nvSpPr>
            <p:spPr bwMode="auto">
              <a:xfrm>
                <a:off x="2047186" y="2753475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34" name="Rectangle 15"/>
              <p:cNvSpPr>
                <a:spLocks noChangeArrowheads="1"/>
              </p:cNvSpPr>
              <p:nvPr/>
            </p:nvSpPr>
            <p:spPr bwMode="auto">
              <a:xfrm>
                <a:off x="1967092" y="3872663"/>
                <a:ext cx="360000" cy="839788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grpSp>
            <p:nvGrpSpPr>
              <p:cNvPr id="275" name="グループ化 274"/>
              <p:cNvGrpSpPr/>
              <p:nvPr/>
            </p:nvGrpSpPr>
            <p:grpSpPr>
              <a:xfrm>
                <a:off x="1102318" y="2066803"/>
                <a:ext cx="6618327" cy="2799009"/>
                <a:chOff x="985080" y="2066803"/>
                <a:chExt cx="6618327" cy="2799009"/>
              </a:xfrm>
            </p:grpSpPr>
            <p:grpSp>
              <p:nvGrpSpPr>
                <p:cNvPr id="274" name="グループ化 273"/>
                <p:cNvGrpSpPr/>
                <p:nvPr/>
              </p:nvGrpSpPr>
              <p:grpSpPr>
                <a:xfrm>
                  <a:off x="985080" y="2066803"/>
                  <a:ext cx="317673" cy="2799009"/>
                  <a:chOff x="985080" y="2066803"/>
                  <a:chExt cx="317673" cy="2799009"/>
                </a:xfrm>
              </p:grpSpPr>
              <p:grpSp>
                <p:nvGrpSpPr>
                  <p:cNvPr id="65" name="グループ化 64"/>
                  <p:cNvGrpSpPr/>
                  <p:nvPr/>
                </p:nvGrpSpPr>
                <p:grpSpPr>
                  <a:xfrm>
                    <a:off x="1248162" y="2081480"/>
                    <a:ext cx="54591" cy="2736000"/>
                    <a:chOff x="-3213650" y="1839430"/>
                    <a:chExt cx="54591" cy="2736000"/>
                  </a:xfrm>
                </p:grpSpPr>
                <p:cxnSp>
                  <p:nvCxnSpPr>
                    <p:cNvPr id="11" name="直線コネクタ 10"/>
                    <p:cNvCxnSpPr/>
                    <p:nvPr/>
                  </p:nvCxnSpPr>
                  <p:spPr>
                    <a:xfrm>
                      <a:off x="-3159059" y="1839430"/>
                      <a:ext cx="0" cy="2736000"/>
                    </a:xfrm>
                    <a:prstGeom prst="line">
                      <a:avLst/>
                    </a:prstGeom>
                    <a:ln w="6350" cap="sq">
                      <a:solidFill>
                        <a:schemeClr val="tx1"/>
                      </a:solidFill>
                      <a:miter lim="800000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grpSp>
                  <p:nvGrpSpPr>
                    <p:cNvPr id="64" name="グループ化 63"/>
                    <p:cNvGrpSpPr/>
                    <p:nvPr/>
                  </p:nvGrpSpPr>
                  <p:grpSpPr>
                    <a:xfrm>
                      <a:off x="-3213650" y="1954046"/>
                      <a:ext cx="54000" cy="2517898"/>
                      <a:chOff x="-3203711" y="1954046"/>
                      <a:chExt cx="54000" cy="2517898"/>
                    </a:xfrm>
                  </p:grpSpPr>
                  <p:cxnSp>
                    <p:nvCxnSpPr>
                      <p:cNvPr id="12" name="直線コネクタ 11"/>
                      <p:cNvCxnSpPr/>
                      <p:nvPr/>
                    </p:nvCxnSpPr>
                    <p:spPr>
                      <a:xfrm>
                        <a:off x="-3203711" y="1954046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3" name="直線コネクタ 12"/>
                      <p:cNvCxnSpPr/>
                      <p:nvPr/>
                    </p:nvCxnSpPr>
                    <p:spPr>
                      <a:xfrm>
                        <a:off x="-3203711" y="2233812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" name="直線コネクタ 13"/>
                      <p:cNvCxnSpPr/>
                      <p:nvPr/>
                    </p:nvCxnSpPr>
                    <p:spPr>
                      <a:xfrm>
                        <a:off x="-3203711" y="2513578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5" name="直線コネクタ 14"/>
                      <p:cNvCxnSpPr/>
                      <p:nvPr/>
                    </p:nvCxnSpPr>
                    <p:spPr>
                      <a:xfrm>
                        <a:off x="-3203711" y="2793344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6" name="直線コネクタ 15"/>
                      <p:cNvCxnSpPr/>
                      <p:nvPr/>
                    </p:nvCxnSpPr>
                    <p:spPr>
                      <a:xfrm>
                        <a:off x="-3203711" y="3073110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7" name="直線コネクタ 16"/>
                      <p:cNvCxnSpPr/>
                      <p:nvPr/>
                    </p:nvCxnSpPr>
                    <p:spPr>
                      <a:xfrm>
                        <a:off x="-3203711" y="3352876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8" name="直線コネクタ 17"/>
                      <p:cNvCxnSpPr/>
                      <p:nvPr/>
                    </p:nvCxnSpPr>
                    <p:spPr>
                      <a:xfrm>
                        <a:off x="-3203711" y="3632642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9" name="直線コネクタ 18"/>
                      <p:cNvCxnSpPr/>
                      <p:nvPr/>
                    </p:nvCxnSpPr>
                    <p:spPr>
                      <a:xfrm>
                        <a:off x="-3203711" y="3912408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0" name="直線コネクタ 19"/>
                      <p:cNvCxnSpPr/>
                      <p:nvPr/>
                    </p:nvCxnSpPr>
                    <p:spPr>
                      <a:xfrm>
                        <a:off x="-3203711" y="4192174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" name="直線コネクタ 20"/>
                      <p:cNvCxnSpPr/>
                      <p:nvPr/>
                    </p:nvCxnSpPr>
                    <p:spPr>
                      <a:xfrm>
                        <a:off x="-3203711" y="4471944"/>
                        <a:ext cx="54000" cy="0"/>
                      </a:xfrm>
                      <a:prstGeom prst="line">
                        <a:avLst/>
                      </a:prstGeom>
                      <a:ln cap="sq">
                        <a:solidFill>
                          <a:schemeClr val="tx1"/>
                        </a:solidFill>
                        <a:miter lim="800000"/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</p:grpSp>
              <p:grpSp>
                <p:nvGrpSpPr>
                  <p:cNvPr id="76" name="グループ化 75"/>
                  <p:cNvGrpSpPr/>
                  <p:nvPr/>
                </p:nvGrpSpPr>
                <p:grpSpPr>
                  <a:xfrm>
                    <a:off x="985080" y="2066803"/>
                    <a:ext cx="261610" cy="2799009"/>
                    <a:chOff x="-2926774" y="1824753"/>
                    <a:chExt cx="261610" cy="2799009"/>
                  </a:xfrm>
                </p:grpSpPr>
                <p:sp>
                  <p:nvSpPr>
                    <p:cNvPr id="66" name="テキスト ボックス 65"/>
                    <p:cNvSpPr txBox="1"/>
                    <p:nvPr/>
                  </p:nvSpPr>
                  <p:spPr>
                    <a:xfrm>
                      <a:off x="-2926774" y="4346763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7" name="テキスト ボックス 66"/>
                    <p:cNvSpPr txBox="1"/>
                    <p:nvPr/>
                  </p:nvSpPr>
                  <p:spPr>
                    <a:xfrm>
                      <a:off x="-2926774" y="4066537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8" name="テキスト ボックス 67"/>
                    <p:cNvSpPr txBox="1"/>
                    <p:nvPr/>
                  </p:nvSpPr>
                  <p:spPr>
                    <a:xfrm>
                      <a:off x="-2926774" y="3786314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9" name="テキスト ボックス 68"/>
                    <p:cNvSpPr txBox="1"/>
                    <p:nvPr/>
                  </p:nvSpPr>
                  <p:spPr>
                    <a:xfrm>
                      <a:off x="-2926774" y="3506091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0" name="テキスト ボックス 69"/>
                    <p:cNvSpPr txBox="1"/>
                    <p:nvPr/>
                  </p:nvSpPr>
                  <p:spPr>
                    <a:xfrm>
                      <a:off x="-2926774" y="3225868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1" name="テキスト ボックス 70"/>
                    <p:cNvSpPr txBox="1"/>
                    <p:nvPr/>
                  </p:nvSpPr>
                  <p:spPr>
                    <a:xfrm>
                      <a:off x="-2926774" y="2945645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2" name="テキスト ボックス 71"/>
                    <p:cNvSpPr txBox="1"/>
                    <p:nvPr/>
                  </p:nvSpPr>
                  <p:spPr>
                    <a:xfrm>
                      <a:off x="-2926774" y="2665422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3" name="テキスト ボックス 72"/>
                    <p:cNvSpPr txBox="1"/>
                    <p:nvPr/>
                  </p:nvSpPr>
                  <p:spPr>
                    <a:xfrm>
                      <a:off x="-2926774" y="2385199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4" name="テキスト ボックス 73"/>
                    <p:cNvSpPr txBox="1"/>
                    <p:nvPr/>
                  </p:nvSpPr>
                  <p:spPr>
                    <a:xfrm>
                      <a:off x="-2926774" y="2104976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75" name="テキスト ボックス 74"/>
                    <p:cNvSpPr txBox="1"/>
                    <p:nvPr/>
                  </p:nvSpPr>
                  <p:spPr>
                    <a:xfrm>
                      <a:off x="-2926774" y="1824753"/>
                      <a:ext cx="261610" cy="27699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kumimoji="1" lang="ja-JP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cxnSp>
              <p:nvCxnSpPr>
                <p:cNvPr id="78" name="直線コネクタ 77"/>
                <p:cNvCxnSpPr/>
                <p:nvPr/>
              </p:nvCxnSpPr>
              <p:spPr>
                <a:xfrm rot="16200000">
                  <a:off x="4453407" y="1674172"/>
                  <a:ext cx="0" cy="6300000"/>
                </a:xfrm>
                <a:prstGeom prst="line">
                  <a:avLst/>
                </a:prstGeom>
                <a:ln w="6350" cap="sq">
                  <a:solidFill>
                    <a:schemeClr val="tx1"/>
                  </a:solidFill>
                  <a:miter lim="800000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4" name="Line 5"/>
              <p:cNvSpPr>
                <a:spLocks noChangeShapeType="1"/>
              </p:cNvSpPr>
              <p:nvPr/>
            </p:nvSpPr>
            <p:spPr bwMode="auto">
              <a:xfrm>
                <a:off x="1549065" y="3032875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30" name="Line 11"/>
              <p:cNvSpPr>
                <a:spLocks noChangeShapeType="1"/>
              </p:cNvSpPr>
              <p:nvPr/>
            </p:nvSpPr>
            <p:spPr bwMode="auto">
              <a:xfrm>
                <a:off x="1967092" y="4153650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3" name="Freeform 49"/>
              <p:cNvSpPr>
                <a:spLocks noEditPoints="1"/>
              </p:cNvSpPr>
              <p:nvPr/>
            </p:nvSpPr>
            <p:spPr bwMode="auto">
              <a:xfrm>
                <a:off x="2760579" y="3309101"/>
                <a:ext cx="0" cy="536575"/>
              </a:xfrm>
              <a:custGeom>
                <a:avLst/>
                <a:gdLst>
                  <a:gd name="T0" fmla="*/ 98 h 98"/>
                  <a:gd name="T1" fmla="*/ 94 h 98"/>
                  <a:gd name="T2" fmla="*/ 90 h 98"/>
                  <a:gd name="T3" fmla="*/ 86 h 98"/>
                  <a:gd name="T4" fmla="*/ 82 h 98"/>
                  <a:gd name="T5" fmla="*/ 78 h 98"/>
                  <a:gd name="T6" fmla="*/ 74 h 98"/>
                  <a:gd name="T7" fmla="*/ 70 h 98"/>
                  <a:gd name="T8" fmla="*/ 66 h 98"/>
                  <a:gd name="T9" fmla="*/ 62 h 98"/>
                  <a:gd name="T10" fmla="*/ 58 h 98"/>
                  <a:gd name="T11" fmla="*/ 54 h 98"/>
                  <a:gd name="T12" fmla="*/ 50 h 98"/>
                  <a:gd name="T13" fmla="*/ 46 h 98"/>
                  <a:gd name="T14" fmla="*/ 42 h 98"/>
                  <a:gd name="T15" fmla="*/ 38 h 98"/>
                  <a:gd name="T16" fmla="*/ 34 h 98"/>
                  <a:gd name="T17" fmla="*/ 30 h 98"/>
                  <a:gd name="T18" fmla="*/ 26 h 98"/>
                  <a:gd name="T19" fmla="*/ 22 h 98"/>
                  <a:gd name="T20" fmla="*/ 18 h 98"/>
                  <a:gd name="T21" fmla="*/ 14 h 98"/>
                  <a:gd name="T22" fmla="*/ 10 h 98"/>
                  <a:gd name="T23" fmla="*/ 6 h 98"/>
                  <a:gd name="T24" fmla="*/ 2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94"/>
                    </a:moveTo>
                    <a:lnTo>
                      <a:pt x="0" y="90"/>
                    </a:lnTo>
                    <a:moveTo>
                      <a:pt x="0" y="86"/>
                    </a:moveTo>
                    <a:lnTo>
                      <a:pt x="0" y="82"/>
                    </a:lnTo>
                    <a:moveTo>
                      <a:pt x="0" y="78"/>
                    </a:moveTo>
                    <a:lnTo>
                      <a:pt x="0" y="74"/>
                    </a:lnTo>
                    <a:moveTo>
                      <a:pt x="0" y="70"/>
                    </a:moveTo>
                    <a:lnTo>
                      <a:pt x="0" y="66"/>
                    </a:lnTo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4" name="Freeform 50"/>
              <p:cNvSpPr>
                <a:spLocks noEditPoints="1"/>
              </p:cNvSpPr>
              <p:nvPr/>
            </p:nvSpPr>
            <p:spPr bwMode="auto">
              <a:xfrm>
                <a:off x="2760579" y="2210551"/>
                <a:ext cx="0" cy="538163"/>
              </a:xfrm>
              <a:custGeom>
                <a:avLst/>
                <a:gdLst>
                  <a:gd name="T0" fmla="*/ 0 h 98"/>
                  <a:gd name="T1" fmla="*/ 4 h 98"/>
                  <a:gd name="T2" fmla="*/ 8 h 98"/>
                  <a:gd name="T3" fmla="*/ 12 h 98"/>
                  <a:gd name="T4" fmla="*/ 16 h 98"/>
                  <a:gd name="T5" fmla="*/ 20 h 98"/>
                  <a:gd name="T6" fmla="*/ 24 h 98"/>
                  <a:gd name="T7" fmla="*/ 28 h 98"/>
                  <a:gd name="T8" fmla="*/ 32 h 98"/>
                  <a:gd name="T9" fmla="*/ 36 h 98"/>
                  <a:gd name="T10" fmla="*/ 40 h 98"/>
                  <a:gd name="T11" fmla="*/ 44 h 98"/>
                  <a:gd name="T12" fmla="*/ 48 h 98"/>
                  <a:gd name="T13" fmla="*/ 52 h 98"/>
                  <a:gd name="T14" fmla="*/ 56 h 98"/>
                  <a:gd name="T15" fmla="*/ 60 h 98"/>
                  <a:gd name="T16" fmla="*/ 64 h 98"/>
                  <a:gd name="T17" fmla="*/ 68 h 98"/>
                  <a:gd name="T18" fmla="*/ 72 h 98"/>
                  <a:gd name="T19" fmla="*/ 76 h 98"/>
                  <a:gd name="T20" fmla="*/ 80 h 98"/>
                  <a:gd name="T21" fmla="*/ 84 h 98"/>
                  <a:gd name="T22" fmla="*/ 88 h 98"/>
                  <a:gd name="T23" fmla="*/ 92 h 98"/>
                  <a:gd name="T24" fmla="*/ 96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5" name="Line 51"/>
              <p:cNvSpPr>
                <a:spLocks noChangeShapeType="1"/>
              </p:cNvSpPr>
              <p:nvPr/>
            </p:nvSpPr>
            <p:spPr bwMode="auto">
              <a:xfrm>
                <a:off x="2651165" y="3867901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6" name="Line 52"/>
              <p:cNvSpPr>
                <a:spLocks noChangeShapeType="1"/>
              </p:cNvSpPr>
              <p:nvPr/>
            </p:nvSpPr>
            <p:spPr bwMode="auto">
              <a:xfrm>
                <a:off x="2651165" y="2188326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7" name="Rectangle 53"/>
              <p:cNvSpPr>
                <a:spLocks noChangeArrowheads="1"/>
              </p:cNvSpPr>
              <p:nvPr/>
            </p:nvSpPr>
            <p:spPr bwMode="auto">
              <a:xfrm>
                <a:off x="2582297" y="2748713"/>
                <a:ext cx="360000" cy="5603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9" name="Freeform 55"/>
              <p:cNvSpPr>
                <a:spLocks noEditPoints="1"/>
              </p:cNvSpPr>
              <p:nvPr/>
            </p:nvSpPr>
            <p:spPr bwMode="auto">
              <a:xfrm>
                <a:off x="3194711" y="2770938"/>
                <a:ext cx="0" cy="1096963"/>
              </a:xfrm>
              <a:custGeom>
                <a:avLst/>
                <a:gdLst>
                  <a:gd name="T0" fmla="*/ 0 h 200"/>
                  <a:gd name="T1" fmla="*/ 4 h 200"/>
                  <a:gd name="T2" fmla="*/ 8 h 200"/>
                  <a:gd name="T3" fmla="*/ 12 h 200"/>
                  <a:gd name="T4" fmla="*/ 16 h 200"/>
                  <a:gd name="T5" fmla="*/ 20 h 200"/>
                  <a:gd name="T6" fmla="*/ 24 h 200"/>
                  <a:gd name="T7" fmla="*/ 28 h 200"/>
                  <a:gd name="T8" fmla="*/ 32 h 200"/>
                  <a:gd name="T9" fmla="*/ 36 h 200"/>
                  <a:gd name="T10" fmla="*/ 40 h 200"/>
                  <a:gd name="T11" fmla="*/ 44 h 200"/>
                  <a:gd name="T12" fmla="*/ 48 h 200"/>
                  <a:gd name="T13" fmla="*/ 52 h 200"/>
                  <a:gd name="T14" fmla="*/ 56 h 200"/>
                  <a:gd name="T15" fmla="*/ 60 h 200"/>
                  <a:gd name="T16" fmla="*/ 64 h 200"/>
                  <a:gd name="T17" fmla="*/ 68 h 200"/>
                  <a:gd name="T18" fmla="*/ 72 h 200"/>
                  <a:gd name="T19" fmla="*/ 76 h 200"/>
                  <a:gd name="T20" fmla="*/ 80 h 200"/>
                  <a:gd name="T21" fmla="*/ 84 h 200"/>
                  <a:gd name="T22" fmla="*/ 88 h 200"/>
                  <a:gd name="T23" fmla="*/ 92 h 200"/>
                  <a:gd name="T24" fmla="*/ 96 h 200"/>
                  <a:gd name="T25" fmla="*/ 100 h 200"/>
                  <a:gd name="T26" fmla="*/ 104 h 200"/>
                  <a:gd name="T27" fmla="*/ 108 h 200"/>
                  <a:gd name="T28" fmla="*/ 112 h 200"/>
                  <a:gd name="T29" fmla="*/ 116 h 200"/>
                  <a:gd name="T30" fmla="*/ 120 h 200"/>
                  <a:gd name="T31" fmla="*/ 124 h 200"/>
                  <a:gd name="T32" fmla="*/ 128 h 200"/>
                  <a:gd name="T33" fmla="*/ 132 h 200"/>
                  <a:gd name="T34" fmla="*/ 136 h 200"/>
                  <a:gd name="T35" fmla="*/ 140 h 200"/>
                  <a:gd name="T36" fmla="*/ 144 h 200"/>
                  <a:gd name="T37" fmla="*/ 148 h 200"/>
                  <a:gd name="T38" fmla="*/ 152 h 200"/>
                  <a:gd name="T39" fmla="*/ 156 h 200"/>
                  <a:gd name="T40" fmla="*/ 160 h 200"/>
                  <a:gd name="T41" fmla="*/ 164 h 200"/>
                  <a:gd name="T42" fmla="*/ 168 h 200"/>
                  <a:gd name="T43" fmla="*/ 172 h 200"/>
                  <a:gd name="T44" fmla="*/ 176 h 200"/>
                  <a:gd name="T45" fmla="*/ 180 h 200"/>
                  <a:gd name="T46" fmla="*/ 184 h 200"/>
                  <a:gd name="T47" fmla="*/ 188 h 200"/>
                  <a:gd name="T48" fmla="*/ 192 h 200"/>
                  <a:gd name="T49" fmla="*/ 196 h 200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  <a:cxn ang="0">
                    <a:pos x="0" y="T47"/>
                  </a:cxn>
                  <a:cxn ang="0">
                    <a:pos x="0" y="T48"/>
                  </a:cxn>
                  <a:cxn ang="0">
                    <a:pos x="0" y="T49"/>
                  </a:cxn>
                </a:cxnLst>
                <a:rect l="0" t="0" r="r" b="b"/>
                <a:pathLst>
                  <a:path h="200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  <a:lnTo>
                      <a:pt x="0" y="152"/>
                    </a:lnTo>
                    <a:moveTo>
                      <a:pt x="0" y="156"/>
                    </a:moveTo>
                    <a:lnTo>
                      <a:pt x="0" y="160"/>
                    </a:lnTo>
                    <a:moveTo>
                      <a:pt x="0" y="164"/>
                    </a:moveTo>
                    <a:lnTo>
                      <a:pt x="0" y="168"/>
                    </a:lnTo>
                    <a:moveTo>
                      <a:pt x="0" y="172"/>
                    </a:moveTo>
                    <a:lnTo>
                      <a:pt x="0" y="176"/>
                    </a:lnTo>
                    <a:moveTo>
                      <a:pt x="0" y="180"/>
                    </a:moveTo>
                    <a:lnTo>
                      <a:pt x="0" y="184"/>
                    </a:lnTo>
                    <a:moveTo>
                      <a:pt x="0" y="188"/>
                    </a:moveTo>
                    <a:lnTo>
                      <a:pt x="0" y="192"/>
                    </a:lnTo>
                    <a:moveTo>
                      <a:pt x="0" y="196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01" name="Line 57"/>
              <p:cNvSpPr>
                <a:spLocks noChangeShapeType="1"/>
              </p:cNvSpPr>
              <p:nvPr/>
            </p:nvSpPr>
            <p:spPr bwMode="auto">
              <a:xfrm>
                <a:off x="3091159" y="274871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02" name="Rectangle 58"/>
              <p:cNvSpPr>
                <a:spLocks noChangeArrowheads="1"/>
              </p:cNvSpPr>
              <p:nvPr/>
            </p:nvSpPr>
            <p:spPr bwMode="auto">
              <a:xfrm>
                <a:off x="3016917" y="3867901"/>
                <a:ext cx="360000" cy="839788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2" name="Line 48"/>
              <p:cNvSpPr>
                <a:spLocks noChangeShapeType="1"/>
              </p:cNvSpPr>
              <p:nvPr/>
            </p:nvSpPr>
            <p:spPr bwMode="auto">
              <a:xfrm>
                <a:off x="2582297" y="3028113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98" name="Line 54"/>
              <p:cNvSpPr>
                <a:spLocks noChangeShapeType="1"/>
              </p:cNvSpPr>
              <p:nvPr/>
            </p:nvSpPr>
            <p:spPr bwMode="auto">
              <a:xfrm>
                <a:off x="3016917" y="4148888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27" name="Freeform 84"/>
              <p:cNvSpPr>
                <a:spLocks noEditPoints="1"/>
              </p:cNvSpPr>
              <p:nvPr/>
            </p:nvSpPr>
            <p:spPr bwMode="auto">
              <a:xfrm>
                <a:off x="3806182" y="3309101"/>
                <a:ext cx="0" cy="536575"/>
              </a:xfrm>
              <a:custGeom>
                <a:avLst/>
                <a:gdLst>
                  <a:gd name="T0" fmla="*/ 98 h 98"/>
                  <a:gd name="T1" fmla="*/ 94 h 98"/>
                  <a:gd name="T2" fmla="*/ 90 h 98"/>
                  <a:gd name="T3" fmla="*/ 86 h 98"/>
                  <a:gd name="T4" fmla="*/ 82 h 98"/>
                  <a:gd name="T5" fmla="*/ 78 h 98"/>
                  <a:gd name="T6" fmla="*/ 74 h 98"/>
                  <a:gd name="T7" fmla="*/ 70 h 98"/>
                  <a:gd name="T8" fmla="*/ 66 h 98"/>
                  <a:gd name="T9" fmla="*/ 62 h 98"/>
                  <a:gd name="T10" fmla="*/ 58 h 98"/>
                  <a:gd name="T11" fmla="*/ 54 h 98"/>
                  <a:gd name="T12" fmla="*/ 50 h 98"/>
                  <a:gd name="T13" fmla="*/ 46 h 98"/>
                  <a:gd name="T14" fmla="*/ 42 h 98"/>
                  <a:gd name="T15" fmla="*/ 38 h 98"/>
                  <a:gd name="T16" fmla="*/ 34 h 98"/>
                  <a:gd name="T17" fmla="*/ 30 h 98"/>
                  <a:gd name="T18" fmla="*/ 26 h 98"/>
                  <a:gd name="T19" fmla="*/ 22 h 98"/>
                  <a:gd name="T20" fmla="*/ 18 h 98"/>
                  <a:gd name="T21" fmla="*/ 14 h 98"/>
                  <a:gd name="T22" fmla="*/ 10 h 98"/>
                  <a:gd name="T23" fmla="*/ 6 h 98"/>
                  <a:gd name="T24" fmla="*/ 2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94"/>
                    </a:moveTo>
                    <a:lnTo>
                      <a:pt x="0" y="90"/>
                    </a:lnTo>
                    <a:moveTo>
                      <a:pt x="0" y="86"/>
                    </a:moveTo>
                    <a:lnTo>
                      <a:pt x="0" y="82"/>
                    </a:lnTo>
                    <a:moveTo>
                      <a:pt x="0" y="78"/>
                    </a:moveTo>
                    <a:lnTo>
                      <a:pt x="0" y="74"/>
                    </a:lnTo>
                    <a:moveTo>
                      <a:pt x="0" y="70"/>
                    </a:moveTo>
                    <a:lnTo>
                      <a:pt x="0" y="66"/>
                    </a:lnTo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28" name="Freeform 85"/>
              <p:cNvSpPr>
                <a:spLocks noEditPoints="1"/>
              </p:cNvSpPr>
              <p:nvPr/>
            </p:nvSpPr>
            <p:spPr bwMode="auto">
              <a:xfrm>
                <a:off x="3806182" y="2210551"/>
                <a:ext cx="0" cy="538163"/>
              </a:xfrm>
              <a:custGeom>
                <a:avLst/>
                <a:gdLst>
                  <a:gd name="T0" fmla="*/ 0 h 98"/>
                  <a:gd name="T1" fmla="*/ 4 h 98"/>
                  <a:gd name="T2" fmla="*/ 8 h 98"/>
                  <a:gd name="T3" fmla="*/ 12 h 98"/>
                  <a:gd name="T4" fmla="*/ 16 h 98"/>
                  <a:gd name="T5" fmla="*/ 20 h 98"/>
                  <a:gd name="T6" fmla="*/ 24 h 98"/>
                  <a:gd name="T7" fmla="*/ 28 h 98"/>
                  <a:gd name="T8" fmla="*/ 32 h 98"/>
                  <a:gd name="T9" fmla="*/ 36 h 98"/>
                  <a:gd name="T10" fmla="*/ 40 h 98"/>
                  <a:gd name="T11" fmla="*/ 44 h 98"/>
                  <a:gd name="T12" fmla="*/ 48 h 98"/>
                  <a:gd name="T13" fmla="*/ 52 h 98"/>
                  <a:gd name="T14" fmla="*/ 56 h 98"/>
                  <a:gd name="T15" fmla="*/ 60 h 98"/>
                  <a:gd name="T16" fmla="*/ 64 h 98"/>
                  <a:gd name="T17" fmla="*/ 68 h 98"/>
                  <a:gd name="T18" fmla="*/ 72 h 98"/>
                  <a:gd name="T19" fmla="*/ 76 h 98"/>
                  <a:gd name="T20" fmla="*/ 80 h 98"/>
                  <a:gd name="T21" fmla="*/ 84 h 98"/>
                  <a:gd name="T22" fmla="*/ 88 h 98"/>
                  <a:gd name="T23" fmla="*/ 92 h 98"/>
                  <a:gd name="T24" fmla="*/ 96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29" name="Line 86"/>
              <p:cNvSpPr>
                <a:spLocks noChangeShapeType="1"/>
              </p:cNvSpPr>
              <p:nvPr/>
            </p:nvSpPr>
            <p:spPr bwMode="auto">
              <a:xfrm>
                <a:off x="3689342" y="3867901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0" name="Line 87"/>
              <p:cNvSpPr>
                <a:spLocks noChangeShapeType="1"/>
              </p:cNvSpPr>
              <p:nvPr/>
            </p:nvSpPr>
            <p:spPr bwMode="auto">
              <a:xfrm>
                <a:off x="3689342" y="2188326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1" name="Rectangle 88"/>
              <p:cNvSpPr>
                <a:spLocks noChangeArrowheads="1"/>
              </p:cNvSpPr>
              <p:nvPr/>
            </p:nvSpPr>
            <p:spPr bwMode="auto">
              <a:xfrm>
                <a:off x="3627112" y="2748713"/>
                <a:ext cx="360000" cy="5603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3" name="Freeform 90"/>
              <p:cNvSpPr>
                <a:spLocks noEditPoints="1"/>
              </p:cNvSpPr>
              <p:nvPr/>
            </p:nvSpPr>
            <p:spPr bwMode="auto">
              <a:xfrm>
                <a:off x="4239502" y="4428288"/>
                <a:ext cx="0" cy="257175"/>
              </a:xfrm>
              <a:custGeom>
                <a:avLst/>
                <a:gdLst>
                  <a:gd name="T0" fmla="*/ 47 h 47"/>
                  <a:gd name="T1" fmla="*/ 43 h 47"/>
                  <a:gd name="T2" fmla="*/ 39 h 47"/>
                  <a:gd name="T3" fmla="*/ 35 h 47"/>
                  <a:gd name="T4" fmla="*/ 31 h 47"/>
                  <a:gd name="T5" fmla="*/ 27 h 47"/>
                  <a:gd name="T6" fmla="*/ 23 h 47"/>
                  <a:gd name="T7" fmla="*/ 19 h 47"/>
                  <a:gd name="T8" fmla="*/ 15 h 47"/>
                  <a:gd name="T9" fmla="*/ 11 h 47"/>
                  <a:gd name="T10" fmla="*/ 7 h 47"/>
                  <a:gd name="T11" fmla="*/ 3 h 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</a:cxnLst>
                <a:rect l="0" t="0" r="r" b="b"/>
                <a:pathLst>
                  <a:path h="47">
                    <a:moveTo>
                      <a:pt x="0" y="43"/>
                    </a:moveTo>
                    <a:lnTo>
                      <a:pt x="0" y="39"/>
                    </a:lnTo>
                    <a:moveTo>
                      <a:pt x="0" y="35"/>
                    </a:moveTo>
                    <a:lnTo>
                      <a:pt x="0" y="31"/>
                    </a:lnTo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4" name="Freeform 91"/>
              <p:cNvSpPr>
                <a:spLocks noEditPoints="1"/>
              </p:cNvSpPr>
              <p:nvPr/>
            </p:nvSpPr>
            <p:spPr bwMode="auto">
              <a:xfrm>
                <a:off x="4239502" y="3050338"/>
                <a:ext cx="0" cy="817563"/>
              </a:xfrm>
              <a:custGeom>
                <a:avLst/>
                <a:gdLst>
                  <a:gd name="T0" fmla="*/ 0 h 149"/>
                  <a:gd name="T1" fmla="*/ 4 h 149"/>
                  <a:gd name="T2" fmla="*/ 8 h 149"/>
                  <a:gd name="T3" fmla="*/ 12 h 149"/>
                  <a:gd name="T4" fmla="*/ 16 h 149"/>
                  <a:gd name="T5" fmla="*/ 20 h 149"/>
                  <a:gd name="T6" fmla="*/ 24 h 149"/>
                  <a:gd name="T7" fmla="*/ 28 h 149"/>
                  <a:gd name="T8" fmla="*/ 32 h 149"/>
                  <a:gd name="T9" fmla="*/ 36 h 149"/>
                  <a:gd name="T10" fmla="*/ 40 h 149"/>
                  <a:gd name="T11" fmla="*/ 44 h 149"/>
                  <a:gd name="T12" fmla="*/ 48 h 149"/>
                  <a:gd name="T13" fmla="*/ 52 h 149"/>
                  <a:gd name="T14" fmla="*/ 56 h 149"/>
                  <a:gd name="T15" fmla="*/ 60 h 149"/>
                  <a:gd name="T16" fmla="*/ 64 h 149"/>
                  <a:gd name="T17" fmla="*/ 68 h 149"/>
                  <a:gd name="T18" fmla="*/ 72 h 149"/>
                  <a:gd name="T19" fmla="*/ 76 h 149"/>
                  <a:gd name="T20" fmla="*/ 80 h 149"/>
                  <a:gd name="T21" fmla="*/ 84 h 149"/>
                  <a:gd name="T22" fmla="*/ 88 h 149"/>
                  <a:gd name="T23" fmla="*/ 92 h 149"/>
                  <a:gd name="T24" fmla="*/ 96 h 149"/>
                  <a:gd name="T25" fmla="*/ 100 h 149"/>
                  <a:gd name="T26" fmla="*/ 104 h 149"/>
                  <a:gd name="T27" fmla="*/ 108 h 149"/>
                  <a:gd name="T28" fmla="*/ 112 h 149"/>
                  <a:gd name="T29" fmla="*/ 116 h 149"/>
                  <a:gd name="T30" fmla="*/ 120 h 149"/>
                  <a:gd name="T31" fmla="*/ 124 h 149"/>
                  <a:gd name="T32" fmla="*/ 128 h 149"/>
                  <a:gd name="T33" fmla="*/ 132 h 149"/>
                  <a:gd name="T34" fmla="*/ 136 h 149"/>
                  <a:gd name="T35" fmla="*/ 140 h 149"/>
                  <a:gd name="T36" fmla="*/ 144 h 149"/>
                  <a:gd name="T37" fmla="*/ 148 h 14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</a:cxnLst>
                <a:rect l="0" t="0" r="r" b="b"/>
                <a:pathLst>
                  <a:path h="14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5" name="Line 92"/>
              <p:cNvSpPr>
                <a:spLocks noChangeShapeType="1"/>
              </p:cNvSpPr>
              <p:nvPr/>
            </p:nvSpPr>
            <p:spPr bwMode="auto">
              <a:xfrm>
                <a:off x="4132822" y="4707688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6" name="Line 93"/>
              <p:cNvSpPr>
                <a:spLocks noChangeShapeType="1"/>
              </p:cNvSpPr>
              <p:nvPr/>
            </p:nvSpPr>
            <p:spPr bwMode="auto">
              <a:xfrm>
                <a:off x="4132822" y="302811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7" name="Rectangle 94"/>
              <p:cNvSpPr>
                <a:spLocks noChangeArrowheads="1"/>
              </p:cNvSpPr>
              <p:nvPr/>
            </p:nvSpPr>
            <p:spPr bwMode="auto">
              <a:xfrm>
                <a:off x="4061702" y="3867901"/>
                <a:ext cx="360000" cy="560388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26" name="Line 83"/>
              <p:cNvSpPr>
                <a:spLocks noChangeShapeType="1"/>
              </p:cNvSpPr>
              <p:nvPr/>
            </p:nvSpPr>
            <p:spPr bwMode="auto">
              <a:xfrm>
                <a:off x="3627112" y="3028113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32" name="Line 89"/>
              <p:cNvSpPr>
                <a:spLocks noChangeShapeType="1"/>
              </p:cNvSpPr>
              <p:nvPr/>
            </p:nvSpPr>
            <p:spPr bwMode="auto">
              <a:xfrm>
                <a:off x="4061702" y="4148888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68" name="Freeform 126"/>
              <p:cNvSpPr>
                <a:spLocks noEditPoints="1"/>
              </p:cNvSpPr>
              <p:nvPr/>
            </p:nvSpPr>
            <p:spPr bwMode="auto">
              <a:xfrm>
                <a:off x="4845052" y="3310688"/>
                <a:ext cx="0" cy="536575"/>
              </a:xfrm>
              <a:custGeom>
                <a:avLst/>
                <a:gdLst>
                  <a:gd name="T0" fmla="*/ 98 h 98"/>
                  <a:gd name="T1" fmla="*/ 94 h 98"/>
                  <a:gd name="T2" fmla="*/ 90 h 98"/>
                  <a:gd name="T3" fmla="*/ 86 h 98"/>
                  <a:gd name="T4" fmla="*/ 82 h 98"/>
                  <a:gd name="T5" fmla="*/ 78 h 98"/>
                  <a:gd name="T6" fmla="*/ 74 h 98"/>
                  <a:gd name="T7" fmla="*/ 70 h 98"/>
                  <a:gd name="T8" fmla="*/ 66 h 98"/>
                  <a:gd name="T9" fmla="*/ 62 h 98"/>
                  <a:gd name="T10" fmla="*/ 58 h 98"/>
                  <a:gd name="T11" fmla="*/ 54 h 98"/>
                  <a:gd name="T12" fmla="*/ 50 h 98"/>
                  <a:gd name="T13" fmla="*/ 46 h 98"/>
                  <a:gd name="T14" fmla="*/ 42 h 98"/>
                  <a:gd name="T15" fmla="*/ 38 h 98"/>
                  <a:gd name="T16" fmla="*/ 34 h 98"/>
                  <a:gd name="T17" fmla="*/ 30 h 98"/>
                  <a:gd name="T18" fmla="*/ 26 h 98"/>
                  <a:gd name="T19" fmla="*/ 22 h 98"/>
                  <a:gd name="T20" fmla="*/ 18 h 98"/>
                  <a:gd name="T21" fmla="*/ 14 h 98"/>
                  <a:gd name="T22" fmla="*/ 10 h 98"/>
                  <a:gd name="T23" fmla="*/ 6 h 98"/>
                  <a:gd name="T24" fmla="*/ 2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94"/>
                    </a:moveTo>
                    <a:lnTo>
                      <a:pt x="0" y="90"/>
                    </a:lnTo>
                    <a:moveTo>
                      <a:pt x="0" y="86"/>
                    </a:moveTo>
                    <a:lnTo>
                      <a:pt x="0" y="82"/>
                    </a:lnTo>
                    <a:moveTo>
                      <a:pt x="0" y="78"/>
                    </a:moveTo>
                    <a:lnTo>
                      <a:pt x="0" y="74"/>
                    </a:lnTo>
                    <a:moveTo>
                      <a:pt x="0" y="70"/>
                    </a:moveTo>
                    <a:lnTo>
                      <a:pt x="0" y="66"/>
                    </a:lnTo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69" name="Freeform 127"/>
              <p:cNvSpPr>
                <a:spLocks noEditPoints="1"/>
              </p:cNvSpPr>
              <p:nvPr/>
            </p:nvSpPr>
            <p:spPr bwMode="auto">
              <a:xfrm>
                <a:off x="4845052" y="2212138"/>
                <a:ext cx="0" cy="258763"/>
              </a:xfrm>
              <a:custGeom>
                <a:avLst/>
                <a:gdLst>
                  <a:gd name="T0" fmla="*/ 0 h 47"/>
                  <a:gd name="T1" fmla="*/ 4 h 47"/>
                  <a:gd name="T2" fmla="*/ 8 h 47"/>
                  <a:gd name="T3" fmla="*/ 12 h 47"/>
                  <a:gd name="T4" fmla="*/ 16 h 47"/>
                  <a:gd name="T5" fmla="*/ 20 h 47"/>
                  <a:gd name="T6" fmla="*/ 24 h 47"/>
                  <a:gd name="T7" fmla="*/ 28 h 47"/>
                  <a:gd name="T8" fmla="*/ 32 h 47"/>
                  <a:gd name="T9" fmla="*/ 36 h 47"/>
                  <a:gd name="T10" fmla="*/ 40 h 47"/>
                  <a:gd name="T11" fmla="*/ 44 h 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</a:cxnLst>
                <a:rect l="0" t="0" r="r" b="b"/>
                <a:pathLst>
                  <a:path h="4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0" name="Line 128"/>
              <p:cNvSpPr>
                <a:spLocks noChangeShapeType="1"/>
              </p:cNvSpPr>
              <p:nvPr/>
            </p:nvSpPr>
            <p:spPr bwMode="auto">
              <a:xfrm>
                <a:off x="4738372" y="3869488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1" name="Line 129"/>
              <p:cNvSpPr>
                <a:spLocks noChangeShapeType="1"/>
              </p:cNvSpPr>
              <p:nvPr/>
            </p:nvSpPr>
            <p:spPr bwMode="auto">
              <a:xfrm>
                <a:off x="4738372" y="218991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2" name="Rectangle 130"/>
              <p:cNvSpPr>
                <a:spLocks noChangeArrowheads="1"/>
              </p:cNvSpPr>
              <p:nvPr/>
            </p:nvSpPr>
            <p:spPr bwMode="auto">
              <a:xfrm>
                <a:off x="4665982" y="2470900"/>
                <a:ext cx="360000" cy="8397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4" name="Freeform 132"/>
              <p:cNvSpPr>
                <a:spLocks noEditPoints="1"/>
              </p:cNvSpPr>
              <p:nvPr/>
            </p:nvSpPr>
            <p:spPr bwMode="auto">
              <a:xfrm>
                <a:off x="5283698" y="4572750"/>
                <a:ext cx="0" cy="114300"/>
              </a:xfrm>
              <a:custGeom>
                <a:avLst/>
                <a:gdLst>
                  <a:gd name="T0" fmla="*/ 21 h 21"/>
                  <a:gd name="T1" fmla="*/ 17 h 21"/>
                  <a:gd name="T2" fmla="*/ 13 h 21"/>
                  <a:gd name="T3" fmla="*/ 9 h 21"/>
                  <a:gd name="T4" fmla="*/ 5 h 21"/>
                  <a:gd name="T5" fmla="*/ 1 h 2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</a:cxnLst>
                <a:rect l="0" t="0" r="r" b="b"/>
                <a:pathLst>
                  <a:path h="21">
                    <a:moveTo>
                      <a:pt x="0" y="17"/>
                    </a:moveTo>
                    <a:lnTo>
                      <a:pt x="0" y="13"/>
                    </a:lnTo>
                    <a:moveTo>
                      <a:pt x="0" y="9"/>
                    </a:moveTo>
                    <a:lnTo>
                      <a:pt x="0" y="5"/>
                    </a:lnTo>
                    <a:moveTo>
                      <a:pt x="0" y="1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5" name="Freeform 133"/>
              <p:cNvSpPr>
                <a:spLocks noEditPoints="1"/>
              </p:cNvSpPr>
              <p:nvPr/>
            </p:nvSpPr>
            <p:spPr bwMode="auto">
              <a:xfrm>
                <a:off x="5283698" y="2212138"/>
                <a:ext cx="0" cy="1377950"/>
              </a:xfrm>
              <a:custGeom>
                <a:avLst/>
                <a:gdLst>
                  <a:gd name="T0" fmla="*/ 0 h 251"/>
                  <a:gd name="T1" fmla="*/ 4 h 251"/>
                  <a:gd name="T2" fmla="*/ 8 h 251"/>
                  <a:gd name="T3" fmla="*/ 12 h 251"/>
                  <a:gd name="T4" fmla="*/ 16 h 251"/>
                  <a:gd name="T5" fmla="*/ 20 h 251"/>
                  <a:gd name="T6" fmla="*/ 24 h 251"/>
                  <a:gd name="T7" fmla="*/ 28 h 251"/>
                  <a:gd name="T8" fmla="*/ 32 h 251"/>
                  <a:gd name="T9" fmla="*/ 36 h 251"/>
                  <a:gd name="T10" fmla="*/ 40 h 251"/>
                  <a:gd name="T11" fmla="*/ 44 h 251"/>
                  <a:gd name="T12" fmla="*/ 48 h 251"/>
                  <a:gd name="T13" fmla="*/ 52 h 251"/>
                  <a:gd name="T14" fmla="*/ 56 h 251"/>
                  <a:gd name="T15" fmla="*/ 60 h 251"/>
                  <a:gd name="T16" fmla="*/ 64 h 251"/>
                  <a:gd name="T17" fmla="*/ 68 h 251"/>
                  <a:gd name="T18" fmla="*/ 72 h 251"/>
                  <a:gd name="T19" fmla="*/ 76 h 251"/>
                  <a:gd name="T20" fmla="*/ 80 h 251"/>
                  <a:gd name="T21" fmla="*/ 84 h 251"/>
                  <a:gd name="T22" fmla="*/ 88 h 251"/>
                  <a:gd name="T23" fmla="*/ 92 h 251"/>
                  <a:gd name="T24" fmla="*/ 96 h 251"/>
                  <a:gd name="T25" fmla="*/ 100 h 251"/>
                  <a:gd name="T26" fmla="*/ 104 h 251"/>
                  <a:gd name="T27" fmla="*/ 108 h 251"/>
                  <a:gd name="T28" fmla="*/ 112 h 251"/>
                  <a:gd name="T29" fmla="*/ 116 h 251"/>
                  <a:gd name="T30" fmla="*/ 120 h 251"/>
                  <a:gd name="T31" fmla="*/ 124 h 251"/>
                  <a:gd name="T32" fmla="*/ 128 h 251"/>
                  <a:gd name="T33" fmla="*/ 132 h 251"/>
                  <a:gd name="T34" fmla="*/ 136 h 251"/>
                  <a:gd name="T35" fmla="*/ 140 h 251"/>
                  <a:gd name="T36" fmla="*/ 144 h 251"/>
                  <a:gd name="T37" fmla="*/ 148 h 251"/>
                  <a:gd name="T38" fmla="*/ 152 h 251"/>
                  <a:gd name="T39" fmla="*/ 156 h 251"/>
                  <a:gd name="T40" fmla="*/ 160 h 251"/>
                  <a:gd name="T41" fmla="*/ 164 h 251"/>
                  <a:gd name="T42" fmla="*/ 168 h 251"/>
                  <a:gd name="T43" fmla="*/ 172 h 251"/>
                  <a:gd name="T44" fmla="*/ 176 h 251"/>
                  <a:gd name="T45" fmla="*/ 180 h 251"/>
                  <a:gd name="T46" fmla="*/ 184 h 251"/>
                  <a:gd name="T47" fmla="*/ 188 h 251"/>
                  <a:gd name="T48" fmla="*/ 192 h 251"/>
                  <a:gd name="T49" fmla="*/ 196 h 251"/>
                  <a:gd name="T50" fmla="*/ 200 h 251"/>
                  <a:gd name="T51" fmla="*/ 204 h 251"/>
                  <a:gd name="T52" fmla="*/ 208 h 251"/>
                  <a:gd name="T53" fmla="*/ 212 h 251"/>
                  <a:gd name="T54" fmla="*/ 216 h 251"/>
                  <a:gd name="T55" fmla="*/ 220 h 251"/>
                  <a:gd name="T56" fmla="*/ 224 h 251"/>
                  <a:gd name="T57" fmla="*/ 228 h 251"/>
                  <a:gd name="T58" fmla="*/ 232 h 251"/>
                  <a:gd name="T59" fmla="*/ 236 h 251"/>
                  <a:gd name="T60" fmla="*/ 240 h 251"/>
                  <a:gd name="T61" fmla="*/ 244 h 251"/>
                  <a:gd name="T62" fmla="*/ 248 h 251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  <a:cxn ang="0">
                    <a:pos x="0" y="T47"/>
                  </a:cxn>
                  <a:cxn ang="0">
                    <a:pos x="0" y="T48"/>
                  </a:cxn>
                  <a:cxn ang="0">
                    <a:pos x="0" y="T49"/>
                  </a:cxn>
                  <a:cxn ang="0">
                    <a:pos x="0" y="T50"/>
                  </a:cxn>
                  <a:cxn ang="0">
                    <a:pos x="0" y="T51"/>
                  </a:cxn>
                  <a:cxn ang="0">
                    <a:pos x="0" y="T52"/>
                  </a:cxn>
                  <a:cxn ang="0">
                    <a:pos x="0" y="T53"/>
                  </a:cxn>
                  <a:cxn ang="0">
                    <a:pos x="0" y="T54"/>
                  </a:cxn>
                  <a:cxn ang="0">
                    <a:pos x="0" y="T55"/>
                  </a:cxn>
                  <a:cxn ang="0">
                    <a:pos x="0" y="T56"/>
                  </a:cxn>
                  <a:cxn ang="0">
                    <a:pos x="0" y="T57"/>
                  </a:cxn>
                  <a:cxn ang="0">
                    <a:pos x="0" y="T58"/>
                  </a:cxn>
                  <a:cxn ang="0">
                    <a:pos x="0" y="T59"/>
                  </a:cxn>
                  <a:cxn ang="0">
                    <a:pos x="0" y="T60"/>
                  </a:cxn>
                  <a:cxn ang="0">
                    <a:pos x="0" y="T61"/>
                  </a:cxn>
                  <a:cxn ang="0">
                    <a:pos x="0" y="T62"/>
                  </a:cxn>
                </a:cxnLst>
                <a:rect l="0" t="0" r="r" b="b"/>
                <a:pathLst>
                  <a:path h="251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  <a:lnTo>
                      <a:pt x="0" y="152"/>
                    </a:lnTo>
                    <a:moveTo>
                      <a:pt x="0" y="156"/>
                    </a:moveTo>
                    <a:lnTo>
                      <a:pt x="0" y="160"/>
                    </a:lnTo>
                    <a:moveTo>
                      <a:pt x="0" y="164"/>
                    </a:moveTo>
                    <a:lnTo>
                      <a:pt x="0" y="168"/>
                    </a:lnTo>
                    <a:moveTo>
                      <a:pt x="0" y="172"/>
                    </a:moveTo>
                    <a:lnTo>
                      <a:pt x="0" y="176"/>
                    </a:lnTo>
                    <a:moveTo>
                      <a:pt x="0" y="180"/>
                    </a:moveTo>
                    <a:lnTo>
                      <a:pt x="0" y="184"/>
                    </a:lnTo>
                    <a:moveTo>
                      <a:pt x="0" y="188"/>
                    </a:moveTo>
                    <a:lnTo>
                      <a:pt x="0" y="192"/>
                    </a:lnTo>
                    <a:moveTo>
                      <a:pt x="0" y="196"/>
                    </a:moveTo>
                    <a:lnTo>
                      <a:pt x="0" y="200"/>
                    </a:lnTo>
                    <a:moveTo>
                      <a:pt x="0" y="204"/>
                    </a:moveTo>
                    <a:lnTo>
                      <a:pt x="0" y="208"/>
                    </a:lnTo>
                    <a:moveTo>
                      <a:pt x="0" y="212"/>
                    </a:moveTo>
                    <a:lnTo>
                      <a:pt x="0" y="216"/>
                    </a:lnTo>
                    <a:moveTo>
                      <a:pt x="0" y="220"/>
                    </a:moveTo>
                    <a:lnTo>
                      <a:pt x="0" y="224"/>
                    </a:lnTo>
                    <a:moveTo>
                      <a:pt x="0" y="228"/>
                    </a:moveTo>
                    <a:lnTo>
                      <a:pt x="0" y="232"/>
                    </a:lnTo>
                    <a:moveTo>
                      <a:pt x="0" y="236"/>
                    </a:moveTo>
                    <a:lnTo>
                      <a:pt x="0" y="240"/>
                    </a:lnTo>
                    <a:moveTo>
                      <a:pt x="0" y="244"/>
                    </a:moveTo>
                    <a:lnTo>
                      <a:pt x="0" y="248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6" name="Line 134"/>
              <p:cNvSpPr>
                <a:spLocks noChangeShapeType="1"/>
              </p:cNvSpPr>
              <p:nvPr/>
            </p:nvSpPr>
            <p:spPr bwMode="auto">
              <a:xfrm>
                <a:off x="5171938" y="4709275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7" name="Line 135"/>
              <p:cNvSpPr>
                <a:spLocks noChangeShapeType="1"/>
              </p:cNvSpPr>
              <p:nvPr/>
            </p:nvSpPr>
            <p:spPr bwMode="auto">
              <a:xfrm>
                <a:off x="5171938" y="218991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8" name="Rectangle 136"/>
              <p:cNvSpPr>
                <a:spLocks noChangeArrowheads="1"/>
              </p:cNvSpPr>
              <p:nvPr/>
            </p:nvSpPr>
            <p:spPr bwMode="auto">
              <a:xfrm>
                <a:off x="5104311" y="3590088"/>
                <a:ext cx="360000" cy="982663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67" name="Line 125"/>
              <p:cNvSpPr>
                <a:spLocks noChangeShapeType="1"/>
              </p:cNvSpPr>
              <p:nvPr/>
            </p:nvSpPr>
            <p:spPr bwMode="auto">
              <a:xfrm>
                <a:off x="4665982" y="2750300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173" name="Line 131"/>
              <p:cNvSpPr>
                <a:spLocks noChangeShapeType="1"/>
              </p:cNvSpPr>
              <p:nvPr/>
            </p:nvSpPr>
            <p:spPr bwMode="auto">
              <a:xfrm>
                <a:off x="5104311" y="4150475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1" name="Freeform 160"/>
              <p:cNvSpPr>
                <a:spLocks noEditPoints="1"/>
              </p:cNvSpPr>
              <p:nvPr/>
            </p:nvSpPr>
            <p:spPr bwMode="auto">
              <a:xfrm>
                <a:off x="5885609" y="3170988"/>
                <a:ext cx="0" cy="679450"/>
              </a:xfrm>
              <a:custGeom>
                <a:avLst/>
                <a:gdLst>
                  <a:gd name="T0" fmla="*/ 124 h 124"/>
                  <a:gd name="T1" fmla="*/ 120 h 124"/>
                  <a:gd name="T2" fmla="*/ 116 h 124"/>
                  <a:gd name="T3" fmla="*/ 112 h 124"/>
                  <a:gd name="T4" fmla="*/ 108 h 124"/>
                  <a:gd name="T5" fmla="*/ 104 h 124"/>
                  <a:gd name="T6" fmla="*/ 100 h 124"/>
                  <a:gd name="T7" fmla="*/ 96 h 124"/>
                  <a:gd name="T8" fmla="*/ 92 h 124"/>
                  <a:gd name="T9" fmla="*/ 88 h 124"/>
                  <a:gd name="T10" fmla="*/ 84 h 124"/>
                  <a:gd name="T11" fmla="*/ 80 h 124"/>
                  <a:gd name="T12" fmla="*/ 76 h 124"/>
                  <a:gd name="T13" fmla="*/ 72 h 124"/>
                  <a:gd name="T14" fmla="*/ 68 h 124"/>
                  <a:gd name="T15" fmla="*/ 64 h 124"/>
                  <a:gd name="T16" fmla="*/ 60 h 124"/>
                  <a:gd name="T17" fmla="*/ 56 h 124"/>
                  <a:gd name="T18" fmla="*/ 52 h 124"/>
                  <a:gd name="T19" fmla="*/ 48 h 124"/>
                  <a:gd name="T20" fmla="*/ 44 h 124"/>
                  <a:gd name="T21" fmla="*/ 40 h 124"/>
                  <a:gd name="T22" fmla="*/ 36 h 124"/>
                  <a:gd name="T23" fmla="*/ 32 h 124"/>
                  <a:gd name="T24" fmla="*/ 28 h 124"/>
                  <a:gd name="T25" fmla="*/ 24 h 124"/>
                  <a:gd name="T26" fmla="*/ 20 h 124"/>
                  <a:gd name="T27" fmla="*/ 16 h 124"/>
                  <a:gd name="T28" fmla="*/ 12 h 124"/>
                  <a:gd name="T29" fmla="*/ 8 h 124"/>
                  <a:gd name="T30" fmla="*/ 4 h 124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</a:cxnLst>
                <a:rect l="0" t="0" r="r" b="b"/>
                <a:pathLst>
                  <a:path h="124">
                    <a:moveTo>
                      <a:pt x="0" y="120"/>
                    </a:moveTo>
                    <a:lnTo>
                      <a:pt x="0" y="116"/>
                    </a:lnTo>
                    <a:moveTo>
                      <a:pt x="0" y="112"/>
                    </a:moveTo>
                    <a:lnTo>
                      <a:pt x="0" y="108"/>
                    </a:lnTo>
                    <a:moveTo>
                      <a:pt x="0" y="104"/>
                    </a:moveTo>
                    <a:lnTo>
                      <a:pt x="0" y="100"/>
                    </a:lnTo>
                    <a:moveTo>
                      <a:pt x="0" y="96"/>
                    </a:moveTo>
                    <a:lnTo>
                      <a:pt x="0" y="92"/>
                    </a:lnTo>
                    <a:moveTo>
                      <a:pt x="0" y="88"/>
                    </a:moveTo>
                    <a:lnTo>
                      <a:pt x="0" y="84"/>
                    </a:lnTo>
                    <a:moveTo>
                      <a:pt x="0" y="80"/>
                    </a:moveTo>
                    <a:lnTo>
                      <a:pt x="0" y="76"/>
                    </a:lnTo>
                    <a:moveTo>
                      <a:pt x="0" y="72"/>
                    </a:moveTo>
                    <a:lnTo>
                      <a:pt x="0" y="68"/>
                    </a:lnTo>
                    <a:moveTo>
                      <a:pt x="0" y="64"/>
                    </a:moveTo>
                    <a:lnTo>
                      <a:pt x="0" y="60"/>
                    </a:lnTo>
                    <a:moveTo>
                      <a:pt x="0" y="56"/>
                    </a:moveTo>
                    <a:lnTo>
                      <a:pt x="0" y="52"/>
                    </a:lnTo>
                    <a:moveTo>
                      <a:pt x="0" y="48"/>
                    </a:moveTo>
                    <a:lnTo>
                      <a:pt x="0" y="44"/>
                    </a:lnTo>
                    <a:moveTo>
                      <a:pt x="0" y="40"/>
                    </a:moveTo>
                    <a:lnTo>
                      <a:pt x="0" y="36"/>
                    </a:lnTo>
                    <a:moveTo>
                      <a:pt x="0" y="32"/>
                    </a:moveTo>
                    <a:lnTo>
                      <a:pt x="0" y="28"/>
                    </a:lnTo>
                    <a:moveTo>
                      <a:pt x="0" y="24"/>
                    </a:moveTo>
                    <a:lnTo>
                      <a:pt x="0" y="20"/>
                    </a:lnTo>
                    <a:moveTo>
                      <a:pt x="0" y="16"/>
                    </a:moveTo>
                    <a:lnTo>
                      <a:pt x="0" y="12"/>
                    </a:lnTo>
                    <a:moveTo>
                      <a:pt x="0" y="8"/>
                    </a:moveTo>
                    <a:lnTo>
                      <a:pt x="0" y="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2" name="Freeform 161"/>
              <p:cNvSpPr>
                <a:spLocks noEditPoints="1"/>
              </p:cNvSpPr>
              <p:nvPr/>
            </p:nvSpPr>
            <p:spPr bwMode="auto">
              <a:xfrm>
                <a:off x="5885609" y="2215313"/>
                <a:ext cx="0" cy="258763"/>
              </a:xfrm>
              <a:custGeom>
                <a:avLst/>
                <a:gdLst>
                  <a:gd name="T0" fmla="*/ 0 h 47"/>
                  <a:gd name="T1" fmla="*/ 4 h 47"/>
                  <a:gd name="T2" fmla="*/ 8 h 47"/>
                  <a:gd name="T3" fmla="*/ 12 h 47"/>
                  <a:gd name="T4" fmla="*/ 16 h 47"/>
                  <a:gd name="T5" fmla="*/ 20 h 47"/>
                  <a:gd name="T6" fmla="*/ 24 h 47"/>
                  <a:gd name="T7" fmla="*/ 28 h 47"/>
                  <a:gd name="T8" fmla="*/ 32 h 47"/>
                  <a:gd name="T9" fmla="*/ 36 h 47"/>
                  <a:gd name="T10" fmla="*/ 40 h 47"/>
                  <a:gd name="T11" fmla="*/ 44 h 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</a:cxnLst>
                <a:rect l="0" t="0" r="r" b="b"/>
                <a:pathLst>
                  <a:path h="47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3" name="Line 162"/>
              <p:cNvSpPr>
                <a:spLocks noChangeShapeType="1"/>
              </p:cNvSpPr>
              <p:nvPr/>
            </p:nvSpPr>
            <p:spPr bwMode="auto">
              <a:xfrm>
                <a:off x="5773849" y="387266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4" name="Line 163"/>
              <p:cNvSpPr>
                <a:spLocks noChangeShapeType="1"/>
              </p:cNvSpPr>
              <p:nvPr/>
            </p:nvSpPr>
            <p:spPr bwMode="auto">
              <a:xfrm>
                <a:off x="5773849" y="2193088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5" name="Rectangle 164"/>
              <p:cNvSpPr>
                <a:spLocks noChangeArrowheads="1"/>
              </p:cNvSpPr>
              <p:nvPr/>
            </p:nvSpPr>
            <p:spPr bwMode="auto">
              <a:xfrm>
                <a:off x="5711619" y="2474075"/>
                <a:ext cx="360000" cy="69691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7" name="Freeform 166"/>
              <p:cNvSpPr>
                <a:spLocks noEditPoints="1"/>
              </p:cNvSpPr>
              <p:nvPr/>
            </p:nvSpPr>
            <p:spPr bwMode="auto">
              <a:xfrm>
                <a:off x="6332777" y="2496300"/>
                <a:ext cx="0" cy="1233488"/>
              </a:xfrm>
              <a:custGeom>
                <a:avLst/>
                <a:gdLst>
                  <a:gd name="T0" fmla="*/ 0 h 225"/>
                  <a:gd name="T1" fmla="*/ 4 h 225"/>
                  <a:gd name="T2" fmla="*/ 8 h 225"/>
                  <a:gd name="T3" fmla="*/ 12 h 225"/>
                  <a:gd name="T4" fmla="*/ 16 h 225"/>
                  <a:gd name="T5" fmla="*/ 20 h 225"/>
                  <a:gd name="T6" fmla="*/ 24 h 225"/>
                  <a:gd name="T7" fmla="*/ 28 h 225"/>
                  <a:gd name="T8" fmla="*/ 32 h 225"/>
                  <a:gd name="T9" fmla="*/ 36 h 225"/>
                  <a:gd name="T10" fmla="*/ 40 h 225"/>
                  <a:gd name="T11" fmla="*/ 44 h 225"/>
                  <a:gd name="T12" fmla="*/ 48 h 225"/>
                  <a:gd name="T13" fmla="*/ 52 h 225"/>
                  <a:gd name="T14" fmla="*/ 56 h 225"/>
                  <a:gd name="T15" fmla="*/ 60 h 225"/>
                  <a:gd name="T16" fmla="*/ 64 h 225"/>
                  <a:gd name="T17" fmla="*/ 68 h 225"/>
                  <a:gd name="T18" fmla="*/ 72 h 225"/>
                  <a:gd name="T19" fmla="*/ 76 h 225"/>
                  <a:gd name="T20" fmla="*/ 80 h 225"/>
                  <a:gd name="T21" fmla="*/ 84 h 225"/>
                  <a:gd name="T22" fmla="*/ 88 h 225"/>
                  <a:gd name="T23" fmla="*/ 92 h 225"/>
                  <a:gd name="T24" fmla="*/ 96 h 225"/>
                  <a:gd name="T25" fmla="*/ 100 h 225"/>
                  <a:gd name="T26" fmla="*/ 104 h 225"/>
                  <a:gd name="T27" fmla="*/ 108 h 225"/>
                  <a:gd name="T28" fmla="*/ 112 h 225"/>
                  <a:gd name="T29" fmla="*/ 116 h 225"/>
                  <a:gd name="T30" fmla="*/ 120 h 225"/>
                  <a:gd name="T31" fmla="*/ 124 h 225"/>
                  <a:gd name="T32" fmla="*/ 128 h 225"/>
                  <a:gd name="T33" fmla="*/ 132 h 225"/>
                  <a:gd name="T34" fmla="*/ 136 h 225"/>
                  <a:gd name="T35" fmla="*/ 140 h 225"/>
                  <a:gd name="T36" fmla="*/ 144 h 225"/>
                  <a:gd name="T37" fmla="*/ 148 h 225"/>
                  <a:gd name="T38" fmla="*/ 152 h 225"/>
                  <a:gd name="T39" fmla="*/ 156 h 225"/>
                  <a:gd name="T40" fmla="*/ 160 h 225"/>
                  <a:gd name="T41" fmla="*/ 164 h 225"/>
                  <a:gd name="T42" fmla="*/ 168 h 225"/>
                  <a:gd name="T43" fmla="*/ 172 h 225"/>
                  <a:gd name="T44" fmla="*/ 176 h 225"/>
                  <a:gd name="T45" fmla="*/ 180 h 225"/>
                  <a:gd name="T46" fmla="*/ 184 h 225"/>
                  <a:gd name="T47" fmla="*/ 188 h 225"/>
                  <a:gd name="T48" fmla="*/ 192 h 225"/>
                  <a:gd name="T49" fmla="*/ 196 h 225"/>
                  <a:gd name="T50" fmla="*/ 200 h 225"/>
                  <a:gd name="T51" fmla="*/ 204 h 225"/>
                  <a:gd name="T52" fmla="*/ 208 h 225"/>
                  <a:gd name="T53" fmla="*/ 212 h 225"/>
                  <a:gd name="T54" fmla="*/ 216 h 225"/>
                  <a:gd name="T55" fmla="*/ 220 h 225"/>
                  <a:gd name="T56" fmla="*/ 224 h 225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  <a:cxn ang="0">
                    <a:pos x="0" y="T38"/>
                  </a:cxn>
                  <a:cxn ang="0">
                    <a:pos x="0" y="T39"/>
                  </a:cxn>
                  <a:cxn ang="0">
                    <a:pos x="0" y="T40"/>
                  </a:cxn>
                  <a:cxn ang="0">
                    <a:pos x="0" y="T41"/>
                  </a:cxn>
                  <a:cxn ang="0">
                    <a:pos x="0" y="T42"/>
                  </a:cxn>
                  <a:cxn ang="0">
                    <a:pos x="0" y="T43"/>
                  </a:cxn>
                  <a:cxn ang="0">
                    <a:pos x="0" y="T44"/>
                  </a:cxn>
                  <a:cxn ang="0">
                    <a:pos x="0" y="T45"/>
                  </a:cxn>
                  <a:cxn ang="0">
                    <a:pos x="0" y="T46"/>
                  </a:cxn>
                  <a:cxn ang="0">
                    <a:pos x="0" y="T47"/>
                  </a:cxn>
                  <a:cxn ang="0">
                    <a:pos x="0" y="T48"/>
                  </a:cxn>
                  <a:cxn ang="0">
                    <a:pos x="0" y="T49"/>
                  </a:cxn>
                  <a:cxn ang="0">
                    <a:pos x="0" y="T50"/>
                  </a:cxn>
                  <a:cxn ang="0">
                    <a:pos x="0" y="T51"/>
                  </a:cxn>
                  <a:cxn ang="0">
                    <a:pos x="0" y="T52"/>
                  </a:cxn>
                  <a:cxn ang="0">
                    <a:pos x="0" y="T53"/>
                  </a:cxn>
                  <a:cxn ang="0">
                    <a:pos x="0" y="T54"/>
                  </a:cxn>
                  <a:cxn ang="0">
                    <a:pos x="0" y="T55"/>
                  </a:cxn>
                  <a:cxn ang="0">
                    <a:pos x="0" y="T56"/>
                  </a:cxn>
                </a:cxnLst>
                <a:rect l="0" t="0" r="r" b="b"/>
                <a:pathLst>
                  <a:path h="225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  <a:lnTo>
                      <a:pt x="0" y="152"/>
                    </a:lnTo>
                    <a:moveTo>
                      <a:pt x="0" y="156"/>
                    </a:moveTo>
                    <a:lnTo>
                      <a:pt x="0" y="160"/>
                    </a:lnTo>
                    <a:moveTo>
                      <a:pt x="0" y="164"/>
                    </a:moveTo>
                    <a:lnTo>
                      <a:pt x="0" y="168"/>
                    </a:lnTo>
                    <a:moveTo>
                      <a:pt x="0" y="172"/>
                    </a:moveTo>
                    <a:lnTo>
                      <a:pt x="0" y="176"/>
                    </a:lnTo>
                    <a:moveTo>
                      <a:pt x="0" y="180"/>
                    </a:moveTo>
                    <a:lnTo>
                      <a:pt x="0" y="184"/>
                    </a:lnTo>
                    <a:moveTo>
                      <a:pt x="0" y="188"/>
                    </a:moveTo>
                    <a:lnTo>
                      <a:pt x="0" y="192"/>
                    </a:lnTo>
                    <a:moveTo>
                      <a:pt x="0" y="196"/>
                    </a:moveTo>
                    <a:lnTo>
                      <a:pt x="0" y="200"/>
                    </a:lnTo>
                    <a:moveTo>
                      <a:pt x="0" y="204"/>
                    </a:moveTo>
                    <a:lnTo>
                      <a:pt x="0" y="208"/>
                    </a:lnTo>
                    <a:moveTo>
                      <a:pt x="0" y="212"/>
                    </a:moveTo>
                    <a:lnTo>
                      <a:pt x="0" y="216"/>
                    </a:lnTo>
                    <a:moveTo>
                      <a:pt x="0" y="220"/>
                    </a:moveTo>
                    <a:lnTo>
                      <a:pt x="0" y="224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9" name="Line 168"/>
              <p:cNvSpPr>
                <a:spLocks noChangeShapeType="1"/>
              </p:cNvSpPr>
              <p:nvPr/>
            </p:nvSpPr>
            <p:spPr bwMode="auto">
              <a:xfrm>
                <a:off x="6215937" y="2474075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10" name="Rectangle 169"/>
              <p:cNvSpPr>
                <a:spLocks noChangeArrowheads="1"/>
              </p:cNvSpPr>
              <p:nvPr/>
            </p:nvSpPr>
            <p:spPr bwMode="auto">
              <a:xfrm>
                <a:off x="6153390" y="3729788"/>
                <a:ext cx="360000" cy="982663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0" name="Line 159"/>
              <p:cNvSpPr>
                <a:spLocks noChangeShapeType="1"/>
              </p:cNvSpPr>
              <p:nvPr/>
            </p:nvSpPr>
            <p:spPr bwMode="auto">
              <a:xfrm>
                <a:off x="5711619" y="3032875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06" name="Line 165"/>
              <p:cNvSpPr>
                <a:spLocks noChangeShapeType="1"/>
              </p:cNvSpPr>
              <p:nvPr/>
            </p:nvSpPr>
            <p:spPr bwMode="auto">
              <a:xfrm>
                <a:off x="6153390" y="4433050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5" name="Freeform 195"/>
              <p:cNvSpPr>
                <a:spLocks noEditPoints="1"/>
              </p:cNvSpPr>
              <p:nvPr/>
            </p:nvSpPr>
            <p:spPr bwMode="auto">
              <a:xfrm>
                <a:off x="6901795" y="3313863"/>
                <a:ext cx="0" cy="536575"/>
              </a:xfrm>
              <a:custGeom>
                <a:avLst/>
                <a:gdLst>
                  <a:gd name="T0" fmla="*/ 98 h 98"/>
                  <a:gd name="T1" fmla="*/ 94 h 98"/>
                  <a:gd name="T2" fmla="*/ 90 h 98"/>
                  <a:gd name="T3" fmla="*/ 86 h 98"/>
                  <a:gd name="T4" fmla="*/ 82 h 98"/>
                  <a:gd name="T5" fmla="*/ 78 h 98"/>
                  <a:gd name="T6" fmla="*/ 74 h 98"/>
                  <a:gd name="T7" fmla="*/ 70 h 98"/>
                  <a:gd name="T8" fmla="*/ 66 h 98"/>
                  <a:gd name="T9" fmla="*/ 62 h 98"/>
                  <a:gd name="T10" fmla="*/ 58 h 98"/>
                  <a:gd name="T11" fmla="*/ 54 h 98"/>
                  <a:gd name="T12" fmla="*/ 50 h 98"/>
                  <a:gd name="T13" fmla="*/ 46 h 98"/>
                  <a:gd name="T14" fmla="*/ 42 h 98"/>
                  <a:gd name="T15" fmla="*/ 38 h 98"/>
                  <a:gd name="T16" fmla="*/ 34 h 98"/>
                  <a:gd name="T17" fmla="*/ 30 h 98"/>
                  <a:gd name="T18" fmla="*/ 26 h 98"/>
                  <a:gd name="T19" fmla="*/ 22 h 98"/>
                  <a:gd name="T20" fmla="*/ 18 h 98"/>
                  <a:gd name="T21" fmla="*/ 14 h 98"/>
                  <a:gd name="T22" fmla="*/ 10 h 98"/>
                  <a:gd name="T23" fmla="*/ 6 h 98"/>
                  <a:gd name="T24" fmla="*/ 2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94"/>
                    </a:moveTo>
                    <a:lnTo>
                      <a:pt x="0" y="90"/>
                    </a:lnTo>
                    <a:moveTo>
                      <a:pt x="0" y="86"/>
                    </a:moveTo>
                    <a:lnTo>
                      <a:pt x="0" y="82"/>
                    </a:lnTo>
                    <a:moveTo>
                      <a:pt x="0" y="78"/>
                    </a:moveTo>
                    <a:lnTo>
                      <a:pt x="0" y="74"/>
                    </a:lnTo>
                    <a:moveTo>
                      <a:pt x="0" y="70"/>
                    </a:moveTo>
                    <a:lnTo>
                      <a:pt x="0" y="66"/>
                    </a:lnTo>
                    <a:moveTo>
                      <a:pt x="0" y="62"/>
                    </a:moveTo>
                    <a:lnTo>
                      <a:pt x="0" y="58"/>
                    </a:lnTo>
                    <a:moveTo>
                      <a:pt x="0" y="54"/>
                    </a:moveTo>
                    <a:lnTo>
                      <a:pt x="0" y="50"/>
                    </a:lnTo>
                    <a:moveTo>
                      <a:pt x="0" y="46"/>
                    </a:moveTo>
                    <a:lnTo>
                      <a:pt x="0" y="42"/>
                    </a:lnTo>
                    <a:moveTo>
                      <a:pt x="0" y="38"/>
                    </a:moveTo>
                    <a:lnTo>
                      <a:pt x="0" y="34"/>
                    </a:lnTo>
                    <a:moveTo>
                      <a:pt x="0" y="30"/>
                    </a:moveTo>
                    <a:lnTo>
                      <a:pt x="0" y="26"/>
                    </a:lnTo>
                    <a:moveTo>
                      <a:pt x="0" y="22"/>
                    </a:moveTo>
                    <a:lnTo>
                      <a:pt x="0" y="18"/>
                    </a:lnTo>
                    <a:moveTo>
                      <a:pt x="0" y="14"/>
                    </a:moveTo>
                    <a:lnTo>
                      <a:pt x="0" y="10"/>
                    </a:lnTo>
                    <a:moveTo>
                      <a:pt x="0" y="6"/>
                    </a:moveTo>
                    <a:lnTo>
                      <a:pt x="0" y="2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6" name="Freeform 196"/>
              <p:cNvSpPr>
                <a:spLocks noEditPoints="1"/>
              </p:cNvSpPr>
              <p:nvPr/>
            </p:nvSpPr>
            <p:spPr bwMode="auto">
              <a:xfrm>
                <a:off x="6901795" y="2215313"/>
                <a:ext cx="0" cy="538163"/>
              </a:xfrm>
              <a:custGeom>
                <a:avLst/>
                <a:gdLst>
                  <a:gd name="T0" fmla="*/ 0 h 98"/>
                  <a:gd name="T1" fmla="*/ 4 h 98"/>
                  <a:gd name="T2" fmla="*/ 8 h 98"/>
                  <a:gd name="T3" fmla="*/ 12 h 98"/>
                  <a:gd name="T4" fmla="*/ 16 h 98"/>
                  <a:gd name="T5" fmla="*/ 20 h 98"/>
                  <a:gd name="T6" fmla="*/ 24 h 98"/>
                  <a:gd name="T7" fmla="*/ 28 h 98"/>
                  <a:gd name="T8" fmla="*/ 32 h 98"/>
                  <a:gd name="T9" fmla="*/ 36 h 98"/>
                  <a:gd name="T10" fmla="*/ 40 h 98"/>
                  <a:gd name="T11" fmla="*/ 44 h 98"/>
                  <a:gd name="T12" fmla="*/ 48 h 98"/>
                  <a:gd name="T13" fmla="*/ 52 h 98"/>
                  <a:gd name="T14" fmla="*/ 56 h 98"/>
                  <a:gd name="T15" fmla="*/ 60 h 98"/>
                  <a:gd name="T16" fmla="*/ 64 h 98"/>
                  <a:gd name="T17" fmla="*/ 68 h 98"/>
                  <a:gd name="T18" fmla="*/ 72 h 98"/>
                  <a:gd name="T19" fmla="*/ 76 h 98"/>
                  <a:gd name="T20" fmla="*/ 80 h 98"/>
                  <a:gd name="T21" fmla="*/ 84 h 98"/>
                  <a:gd name="T22" fmla="*/ 88 h 98"/>
                  <a:gd name="T23" fmla="*/ 92 h 98"/>
                  <a:gd name="T24" fmla="*/ 96 h 98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</a:cxnLst>
                <a:rect l="0" t="0" r="r" b="b"/>
                <a:pathLst>
                  <a:path h="98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7" name="Line 197"/>
              <p:cNvSpPr>
                <a:spLocks noChangeShapeType="1"/>
              </p:cNvSpPr>
              <p:nvPr/>
            </p:nvSpPr>
            <p:spPr bwMode="auto">
              <a:xfrm>
                <a:off x="6784955" y="3872663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8" name="Line 198"/>
              <p:cNvSpPr>
                <a:spLocks noChangeShapeType="1"/>
              </p:cNvSpPr>
              <p:nvPr/>
            </p:nvSpPr>
            <p:spPr bwMode="auto">
              <a:xfrm>
                <a:off x="6784955" y="2193088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9" name="Rectangle 199"/>
              <p:cNvSpPr>
                <a:spLocks noChangeArrowheads="1"/>
              </p:cNvSpPr>
              <p:nvPr/>
            </p:nvSpPr>
            <p:spPr bwMode="auto">
              <a:xfrm>
                <a:off x="6722725" y="2753475"/>
                <a:ext cx="360000" cy="56038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1" name="Freeform 201"/>
              <p:cNvSpPr>
                <a:spLocks noEditPoints="1"/>
              </p:cNvSpPr>
              <p:nvPr/>
            </p:nvSpPr>
            <p:spPr bwMode="auto">
              <a:xfrm>
                <a:off x="7331775" y="4433050"/>
                <a:ext cx="0" cy="257175"/>
              </a:xfrm>
              <a:custGeom>
                <a:avLst/>
                <a:gdLst>
                  <a:gd name="T0" fmla="*/ 47 h 47"/>
                  <a:gd name="T1" fmla="*/ 43 h 47"/>
                  <a:gd name="T2" fmla="*/ 39 h 47"/>
                  <a:gd name="T3" fmla="*/ 35 h 47"/>
                  <a:gd name="T4" fmla="*/ 31 h 47"/>
                  <a:gd name="T5" fmla="*/ 27 h 47"/>
                  <a:gd name="T6" fmla="*/ 23 h 47"/>
                  <a:gd name="T7" fmla="*/ 19 h 47"/>
                  <a:gd name="T8" fmla="*/ 15 h 47"/>
                  <a:gd name="T9" fmla="*/ 11 h 47"/>
                  <a:gd name="T10" fmla="*/ 7 h 47"/>
                  <a:gd name="T11" fmla="*/ 3 h 47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</a:cxnLst>
                <a:rect l="0" t="0" r="r" b="b"/>
                <a:pathLst>
                  <a:path h="47">
                    <a:moveTo>
                      <a:pt x="0" y="43"/>
                    </a:moveTo>
                    <a:lnTo>
                      <a:pt x="0" y="39"/>
                    </a:lnTo>
                    <a:moveTo>
                      <a:pt x="0" y="35"/>
                    </a:moveTo>
                    <a:lnTo>
                      <a:pt x="0" y="31"/>
                    </a:lnTo>
                    <a:moveTo>
                      <a:pt x="0" y="27"/>
                    </a:moveTo>
                    <a:lnTo>
                      <a:pt x="0" y="23"/>
                    </a:lnTo>
                    <a:moveTo>
                      <a:pt x="0" y="19"/>
                    </a:moveTo>
                    <a:lnTo>
                      <a:pt x="0" y="15"/>
                    </a:lnTo>
                    <a:moveTo>
                      <a:pt x="0" y="11"/>
                    </a:moveTo>
                    <a:lnTo>
                      <a:pt x="0" y="7"/>
                    </a:lnTo>
                    <a:moveTo>
                      <a:pt x="0" y="3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2" name="Freeform 202"/>
              <p:cNvSpPr>
                <a:spLocks noEditPoints="1"/>
              </p:cNvSpPr>
              <p:nvPr/>
            </p:nvSpPr>
            <p:spPr bwMode="auto">
              <a:xfrm>
                <a:off x="7331775" y="3055100"/>
                <a:ext cx="0" cy="817563"/>
              </a:xfrm>
              <a:custGeom>
                <a:avLst/>
                <a:gdLst>
                  <a:gd name="T0" fmla="*/ 0 h 149"/>
                  <a:gd name="T1" fmla="*/ 4 h 149"/>
                  <a:gd name="T2" fmla="*/ 8 h 149"/>
                  <a:gd name="T3" fmla="*/ 12 h 149"/>
                  <a:gd name="T4" fmla="*/ 16 h 149"/>
                  <a:gd name="T5" fmla="*/ 20 h 149"/>
                  <a:gd name="T6" fmla="*/ 24 h 149"/>
                  <a:gd name="T7" fmla="*/ 28 h 149"/>
                  <a:gd name="T8" fmla="*/ 32 h 149"/>
                  <a:gd name="T9" fmla="*/ 36 h 149"/>
                  <a:gd name="T10" fmla="*/ 40 h 149"/>
                  <a:gd name="T11" fmla="*/ 44 h 149"/>
                  <a:gd name="T12" fmla="*/ 48 h 149"/>
                  <a:gd name="T13" fmla="*/ 52 h 149"/>
                  <a:gd name="T14" fmla="*/ 56 h 149"/>
                  <a:gd name="T15" fmla="*/ 60 h 149"/>
                  <a:gd name="T16" fmla="*/ 64 h 149"/>
                  <a:gd name="T17" fmla="*/ 68 h 149"/>
                  <a:gd name="T18" fmla="*/ 72 h 149"/>
                  <a:gd name="T19" fmla="*/ 76 h 149"/>
                  <a:gd name="T20" fmla="*/ 80 h 149"/>
                  <a:gd name="T21" fmla="*/ 84 h 149"/>
                  <a:gd name="T22" fmla="*/ 88 h 149"/>
                  <a:gd name="T23" fmla="*/ 92 h 149"/>
                  <a:gd name="T24" fmla="*/ 96 h 149"/>
                  <a:gd name="T25" fmla="*/ 100 h 149"/>
                  <a:gd name="T26" fmla="*/ 104 h 149"/>
                  <a:gd name="T27" fmla="*/ 108 h 149"/>
                  <a:gd name="T28" fmla="*/ 112 h 149"/>
                  <a:gd name="T29" fmla="*/ 116 h 149"/>
                  <a:gd name="T30" fmla="*/ 120 h 149"/>
                  <a:gd name="T31" fmla="*/ 124 h 149"/>
                  <a:gd name="T32" fmla="*/ 128 h 149"/>
                  <a:gd name="T33" fmla="*/ 132 h 149"/>
                  <a:gd name="T34" fmla="*/ 136 h 149"/>
                  <a:gd name="T35" fmla="*/ 140 h 149"/>
                  <a:gd name="T36" fmla="*/ 144 h 149"/>
                  <a:gd name="T37" fmla="*/ 148 h 149"/>
                </a:gdLst>
                <a:ahLst/>
                <a:cxnLst>
                  <a:cxn ang="0">
                    <a:pos x="0" y="T0"/>
                  </a:cxn>
                  <a:cxn ang="0">
                    <a:pos x="0" y="T1"/>
                  </a:cxn>
                  <a:cxn ang="0">
                    <a:pos x="0" y="T2"/>
                  </a:cxn>
                  <a:cxn ang="0">
                    <a:pos x="0" y="T3"/>
                  </a:cxn>
                  <a:cxn ang="0">
                    <a:pos x="0" y="T4"/>
                  </a:cxn>
                  <a:cxn ang="0">
                    <a:pos x="0" y="T5"/>
                  </a:cxn>
                  <a:cxn ang="0">
                    <a:pos x="0" y="T6"/>
                  </a:cxn>
                  <a:cxn ang="0">
                    <a:pos x="0" y="T7"/>
                  </a:cxn>
                  <a:cxn ang="0">
                    <a:pos x="0" y="T8"/>
                  </a:cxn>
                  <a:cxn ang="0">
                    <a:pos x="0" y="T9"/>
                  </a:cxn>
                  <a:cxn ang="0">
                    <a:pos x="0" y="T10"/>
                  </a:cxn>
                  <a:cxn ang="0">
                    <a:pos x="0" y="T11"/>
                  </a:cxn>
                  <a:cxn ang="0">
                    <a:pos x="0" y="T12"/>
                  </a:cxn>
                  <a:cxn ang="0">
                    <a:pos x="0" y="T13"/>
                  </a:cxn>
                  <a:cxn ang="0">
                    <a:pos x="0" y="T14"/>
                  </a:cxn>
                  <a:cxn ang="0">
                    <a:pos x="0" y="T15"/>
                  </a:cxn>
                  <a:cxn ang="0">
                    <a:pos x="0" y="T16"/>
                  </a:cxn>
                  <a:cxn ang="0">
                    <a:pos x="0" y="T17"/>
                  </a:cxn>
                  <a:cxn ang="0">
                    <a:pos x="0" y="T18"/>
                  </a:cxn>
                  <a:cxn ang="0">
                    <a:pos x="0" y="T19"/>
                  </a:cxn>
                  <a:cxn ang="0">
                    <a:pos x="0" y="T20"/>
                  </a:cxn>
                  <a:cxn ang="0">
                    <a:pos x="0" y="T21"/>
                  </a:cxn>
                  <a:cxn ang="0">
                    <a:pos x="0" y="T22"/>
                  </a:cxn>
                  <a:cxn ang="0">
                    <a:pos x="0" y="T23"/>
                  </a:cxn>
                  <a:cxn ang="0">
                    <a:pos x="0" y="T24"/>
                  </a:cxn>
                  <a:cxn ang="0">
                    <a:pos x="0" y="T25"/>
                  </a:cxn>
                  <a:cxn ang="0">
                    <a:pos x="0" y="T26"/>
                  </a:cxn>
                  <a:cxn ang="0">
                    <a:pos x="0" y="T27"/>
                  </a:cxn>
                  <a:cxn ang="0">
                    <a:pos x="0" y="T28"/>
                  </a:cxn>
                  <a:cxn ang="0">
                    <a:pos x="0" y="T29"/>
                  </a:cxn>
                  <a:cxn ang="0">
                    <a:pos x="0" y="T30"/>
                  </a:cxn>
                  <a:cxn ang="0">
                    <a:pos x="0" y="T31"/>
                  </a:cxn>
                  <a:cxn ang="0">
                    <a:pos x="0" y="T32"/>
                  </a:cxn>
                  <a:cxn ang="0">
                    <a:pos x="0" y="T33"/>
                  </a:cxn>
                  <a:cxn ang="0">
                    <a:pos x="0" y="T34"/>
                  </a:cxn>
                  <a:cxn ang="0">
                    <a:pos x="0" y="T35"/>
                  </a:cxn>
                  <a:cxn ang="0">
                    <a:pos x="0" y="T36"/>
                  </a:cxn>
                  <a:cxn ang="0">
                    <a:pos x="0" y="T37"/>
                  </a:cxn>
                </a:cxnLst>
                <a:rect l="0" t="0" r="r" b="b"/>
                <a:pathLst>
                  <a:path h="149">
                    <a:moveTo>
                      <a:pt x="0" y="4"/>
                    </a:moveTo>
                    <a:lnTo>
                      <a:pt x="0" y="8"/>
                    </a:lnTo>
                    <a:moveTo>
                      <a:pt x="0" y="12"/>
                    </a:moveTo>
                    <a:lnTo>
                      <a:pt x="0" y="16"/>
                    </a:lnTo>
                    <a:moveTo>
                      <a:pt x="0" y="20"/>
                    </a:moveTo>
                    <a:lnTo>
                      <a:pt x="0" y="24"/>
                    </a:lnTo>
                    <a:moveTo>
                      <a:pt x="0" y="28"/>
                    </a:moveTo>
                    <a:lnTo>
                      <a:pt x="0" y="32"/>
                    </a:lnTo>
                    <a:moveTo>
                      <a:pt x="0" y="36"/>
                    </a:moveTo>
                    <a:lnTo>
                      <a:pt x="0" y="40"/>
                    </a:lnTo>
                    <a:moveTo>
                      <a:pt x="0" y="44"/>
                    </a:moveTo>
                    <a:lnTo>
                      <a:pt x="0" y="48"/>
                    </a:lnTo>
                    <a:moveTo>
                      <a:pt x="0" y="52"/>
                    </a:moveTo>
                    <a:lnTo>
                      <a:pt x="0" y="56"/>
                    </a:lnTo>
                    <a:moveTo>
                      <a:pt x="0" y="60"/>
                    </a:moveTo>
                    <a:lnTo>
                      <a:pt x="0" y="64"/>
                    </a:lnTo>
                    <a:moveTo>
                      <a:pt x="0" y="68"/>
                    </a:moveTo>
                    <a:lnTo>
                      <a:pt x="0" y="72"/>
                    </a:lnTo>
                    <a:moveTo>
                      <a:pt x="0" y="76"/>
                    </a:moveTo>
                    <a:lnTo>
                      <a:pt x="0" y="80"/>
                    </a:lnTo>
                    <a:moveTo>
                      <a:pt x="0" y="84"/>
                    </a:moveTo>
                    <a:lnTo>
                      <a:pt x="0" y="88"/>
                    </a:lnTo>
                    <a:moveTo>
                      <a:pt x="0" y="92"/>
                    </a:moveTo>
                    <a:lnTo>
                      <a:pt x="0" y="96"/>
                    </a:lnTo>
                    <a:moveTo>
                      <a:pt x="0" y="100"/>
                    </a:moveTo>
                    <a:lnTo>
                      <a:pt x="0" y="104"/>
                    </a:lnTo>
                    <a:moveTo>
                      <a:pt x="0" y="108"/>
                    </a:moveTo>
                    <a:lnTo>
                      <a:pt x="0" y="112"/>
                    </a:lnTo>
                    <a:moveTo>
                      <a:pt x="0" y="116"/>
                    </a:moveTo>
                    <a:lnTo>
                      <a:pt x="0" y="120"/>
                    </a:lnTo>
                    <a:moveTo>
                      <a:pt x="0" y="124"/>
                    </a:moveTo>
                    <a:lnTo>
                      <a:pt x="0" y="128"/>
                    </a:lnTo>
                    <a:moveTo>
                      <a:pt x="0" y="132"/>
                    </a:moveTo>
                    <a:lnTo>
                      <a:pt x="0" y="136"/>
                    </a:lnTo>
                    <a:moveTo>
                      <a:pt x="0" y="140"/>
                    </a:moveTo>
                    <a:lnTo>
                      <a:pt x="0" y="144"/>
                    </a:lnTo>
                    <a:moveTo>
                      <a:pt x="0" y="148"/>
                    </a:moveTo>
                  </a:path>
                </a:pathLst>
              </a:cu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3" name="Line 203"/>
              <p:cNvSpPr>
                <a:spLocks noChangeShapeType="1"/>
              </p:cNvSpPr>
              <p:nvPr/>
            </p:nvSpPr>
            <p:spPr bwMode="auto">
              <a:xfrm>
                <a:off x="7214935" y="4712450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4" name="Line 204"/>
              <p:cNvSpPr>
                <a:spLocks noChangeShapeType="1"/>
              </p:cNvSpPr>
              <p:nvPr/>
            </p:nvSpPr>
            <p:spPr bwMode="auto">
              <a:xfrm>
                <a:off x="7214935" y="3032875"/>
                <a:ext cx="216000" cy="0"/>
              </a:xfrm>
              <a:prstGeom prst="line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5" name="Rectangle 205"/>
              <p:cNvSpPr>
                <a:spLocks noChangeArrowheads="1"/>
              </p:cNvSpPr>
              <p:nvPr/>
            </p:nvSpPr>
            <p:spPr bwMode="auto">
              <a:xfrm>
                <a:off x="7153975" y="3872663"/>
                <a:ext cx="360000" cy="560388"/>
              </a:xfrm>
              <a:prstGeom prst="rect">
                <a:avLst/>
              </a:prstGeom>
              <a:noFill/>
              <a:ln w="4763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34" name="Line 194"/>
              <p:cNvSpPr>
                <a:spLocks noChangeShapeType="1"/>
              </p:cNvSpPr>
              <p:nvPr/>
            </p:nvSpPr>
            <p:spPr bwMode="auto">
              <a:xfrm>
                <a:off x="6722725" y="3032875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sp>
            <p:nvSpPr>
              <p:cNvPr id="240" name="Line 200"/>
              <p:cNvSpPr>
                <a:spLocks noChangeShapeType="1"/>
              </p:cNvSpPr>
              <p:nvPr/>
            </p:nvSpPr>
            <p:spPr bwMode="auto">
              <a:xfrm>
                <a:off x="7153975" y="4153650"/>
                <a:ext cx="360000" cy="0"/>
              </a:xfrm>
              <a:prstGeom prst="line">
                <a:avLst/>
              </a:prstGeom>
              <a:noFill/>
              <a:ln w="1587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dirty="0"/>
              </a:p>
            </p:txBody>
          </p:sp>
          <p:grpSp>
            <p:nvGrpSpPr>
              <p:cNvPr id="278" name="グループ化 277"/>
              <p:cNvGrpSpPr/>
              <p:nvPr/>
            </p:nvGrpSpPr>
            <p:grpSpPr>
              <a:xfrm>
                <a:off x="2120040" y="2175177"/>
                <a:ext cx="43200" cy="318973"/>
                <a:chOff x="2060865" y="2175177"/>
                <a:chExt cx="43200" cy="318973"/>
              </a:xfrm>
            </p:grpSpPr>
            <p:sp>
              <p:nvSpPr>
                <p:cNvPr id="276" name="円/楕円 275"/>
                <p:cNvSpPr/>
                <p:nvPr/>
              </p:nvSpPr>
              <p:spPr>
                <a:xfrm>
                  <a:off x="2060865" y="2175177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77" name="円/楕円 276"/>
                <p:cNvSpPr/>
                <p:nvPr/>
              </p:nvSpPr>
              <p:spPr>
                <a:xfrm>
                  <a:off x="2060865" y="2450950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79" name="グループ化 278"/>
              <p:cNvGrpSpPr/>
              <p:nvPr/>
            </p:nvGrpSpPr>
            <p:grpSpPr>
              <a:xfrm>
                <a:off x="3175959" y="2175174"/>
                <a:ext cx="43200" cy="318973"/>
                <a:chOff x="2060865" y="2175177"/>
                <a:chExt cx="43200" cy="318973"/>
              </a:xfrm>
            </p:grpSpPr>
            <p:sp>
              <p:nvSpPr>
                <p:cNvPr id="280" name="円/楕円 279"/>
                <p:cNvSpPr/>
                <p:nvPr/>
              </p:nvSpPr>
              <p:spPr>
                <a:xfrm>
                  <a:off x="2060865" y="2175177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81" name="円/楕円 280"/>
                <p:cNvSpPr/>
                <p:nvPr/>
              </p:nvSpPr>
              <p:spPr>
                <a:xfrm>
                  <a:off x="2060865" y="2450950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grpSp>
            <p:nvGrpSpPr>
              <p:cNvPr id="286" name="グループ化 285"/>
              <p:cNvGrpSpPr/>
              <p:nvPr/>
            </p:nvGrpSpPr>
            <p:grpSpPr>
              <a:xfrm>
                <a:off x="4217358" y="2175171"/>
                <a:ext cx="43200" cy="594745"/>
                <a:chOff x="4234382" y="2175171"/>
                <a:chExt cx="43200" cy="594745"/>
              </a:xfrm>
            </p:grpSpPr>
            <p:sp>
              <p:nvSpPr>
                <p:cNvPr id="283" name="円/楕円 282"/>
                <p:cNvSpPr/>
                <p:nvPr/>
              </p:nvSpPr>
              <p:spPr>
                <a:xfrm>
                  <a:off x="4234382" y="2175171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84" name="円/楕円 283"/>
                <p:cNvSpPr/>
                <p:nvPr/>
              </p:nvSpPr>
              <p:spPr>
                <a:xfrm>
                  <a:off x="4234382" y="2450944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85" name="円/楕円 284"/>
                <p:cNvSpPr/>
                <p:nvPr/>
              </p:nvSpPr>
              <p:spPr>
                <a:xfrm>
                  <a:off x="4234382" y="2726716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sp>
            <p:nvSpPr>
              <p:cNvPr id="288" name="円/楕円 287"/>
              <p:cNvSpPr/>
              <p:nvPr/>
            </p:nvSpPr>
            <p:spPr>
              <a:xfrm>
                <a:off x="6314691" y="2171547"/>
                <a:ext cx="43200" cy="43200"/>
              </a:xfrm>
              <a:prstGeom prst="ellipse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grpSp>
            <p:nvGrpSpPr>
              <p:cNvPr id="290" name="グループ化 289"/>
              <p:cNvGrpSpPr/>
              <p:nvPr/>
            </p:nvGrpSpPr>
            <p:grpSpPr>
              <a:xfrm>
                <a:off x="7305292" y="2178798"/>
                <a:ext cx="43200" cy="594745"/>
                <a:chOff x="4234382" y="2175171"/>
                <a:chExt cx="43200" cy="594745"/>
              </a:xfrm>
            </p:grpSpPr>
            <p:sp>
              <p:nvSpPr>
                <p:cNvPr id="291" name="円/楕円 290"/>
                <p:cNvSpPr/>
                <p:nvPr/>
              </p:nvSpPr>
              <p:spPr>
                <a:xfrm>
                  <a:off x="4234382" y="2175171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93" name="円/楕円 292"/>
                <p:cNvSpPr/>
                <p:nvPr/>
              </p:nvSpPr>
              <p:spPr>
                <a:xfrm>
                  <a:off x="4234382" y="2726716"/>
                  <a:ext cx="43200" cy="43200"/>
                </a:xfrm>
                <a:prstGeom prst="ellipse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</p:grpSp>
        <p:sp>
          <p:nvSpPr>
            <p:cNvPr id="295" name="テキスト ボックス 294"/>
            <p:cNvSpPr txBox="1"/>
            <p:nvPr/>
          </p:nvSpPr>
          <p:spPr>
            <a:xfrm rot="16200000">
              <a:off x="366209" y="3305230"/>
              <a:ext cx="11192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Mayo score</a:t>
              </a:r>
              <a:endParaRPr kumimoji="1" lang="ja-JP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8" name="テキスト ボックス 297"/>
          <p:cNvSpPr txBox="1"/>
          <p:nvPr/>
        </p:nvSpPr>
        <p:spPr>
          <a:xfrm>
            <a:off x="1205051" y="5591196"/>
            <a:ext cx="731332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ay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cores at baseline and at the final assessment time in the five major special situation sub-groups of patients with UC. </a:t>
            </a:r>
            <a:r>
              <a:rPr lang="en-US" altLang="ja-JP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Mayo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rtial Mayo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UC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cerative colitis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MA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nulocyte and monocyte adsorptive apheresis</a:t>
            </a:r>
          </a:p>
        </p:txBody>
      </p:sp>
      <p:sp>
        <p:nvSpPr>
          <p:cNvPr id="299" name="テキスト ボックス 298"/>
          <p:cNvSpPr txBox="1"/>
          <p:nvPr/>
        </p:nvSpPr>
        <p:spPr>
          <a:xfrm>
            <a:off x="4941463" y="5169040"/>
            <a:ext cx="38724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kumimoji="1"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kumimoji="1"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, </a:t>
            </a:r>
            <a:r>
              <a:rPr kumimoji="1" lang="en-US" altLang="ja-JP" sz="11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kumimoji="1" lang="en-US" altLang="ja-JP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 by Wilcoxon signed rank test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正方形/長方形 299"/>
          <p:cNvSpPr/>
          <p:nvPr/>
        </p:nvSpPr>
        <p:spPr>
          <a:xfrm>
            <a:off x="2378807" y="1389435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  <p:sp>
        <p:nvSpPr>
          <p:cNvPr id="301" name="正方形/長方形 300"/>
          <p:cNvSpPr/>
          <p:nvPr/>
        </p:nvSpPr>
        <p:spPr>
          <a:xfrm>
            <a:off x="3428023" y="1389433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  <p:sp>
        <p:nvSpPr>
          <p:cNvPr id="302" name="正方形/長方形 301"/>
          <p:cNvSpPr/>
          <p:nvPr/>
        </p:nvSpPr>
        <p:spPr>
          <a:xfrm>
            <a:off x="4477244" y="167079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  <p:sp>
        <p:nvSpPr>
          <p:cNvPr id="303" name="正方形/長方形 302"/>
          <p:cNvSpPr/>
          <p:nvPr/>
        </p:nvSpPr>
        <p:spPr>
          <a:xfrm>
            <a:off x="5514734" y="826731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  <p:sp>
        <p:nvSpPr>
          <p:cNvPr id="304" name="正方形/長方形 303"/>
          <p:cNvSpPr/>
          <p:nvPr/>
        </p:nvSpPr>
        <p:spPr>
          <a:xfrm>
            <a:off x="6563950" y="1113949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  <p:sp>
        <p:nvSpPr>
          <p:cNvPr id="305" name="正方形/長方形 304"/>
          <p:cNvSpPr/>
          <p:nvPr/>
        </p:nvSpPr>
        <p:spPr>
          <a:xfrm>
            <a:off x="7566277" y="1670802"/>
            <a:ext cx="26161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ja-JP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267310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41</TotalTime>
  <Words>126</Words>
  <Application>Microsoft Office PowerPoint</Application>
  <PresentationFormat>画面に合わせる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>JIMRO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kuma Seiichiro（国馬 誠一郎）</dc:creator>
  <cp:lastModifiedBy>hosoi eiji（細井　栄治）</cp:lastModifiedBy>
  <cp:revision>1016</cp:revision>
  <cp:lastPrinted>2018-11-09T05:42:12Z</cp:lastPrinted>
  <dcterms:created xsi:type="dcterms:W3CDTF">2017-02-06T05:38:59Z</dcterms:created>
  <dcterms:modified xsi:type="dcterms:W3CDTF">2019-09-26T02:27:42Z</dcterms:modified>
</cp:coreProperties>
</file>